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278" r:id="rId2"/>
    <p:sldId id="263" r:id="rId3"/>
    <p:sldId id="265" r:id="rId4"/>
    <p:sldId id="268" r:id="rId5"/>
    <p:sldId id="271" r:id="rId6"/>
    <p:sldId id="266" r:id="rId7"/>
    <p:sldId id="267" r:id="rId8"/>
    <p:sldId id="276" r:id="rId9"/>
    <p:sldId id="279" r:id="rId10"/>
    <p:sldId id="275" r:id="rId11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7355A"/>
    <a:srgbClr val="3520B2"/>
    <a:srgbClr val="EB2DDD"/>
    <a:srgbClr val="2B1A92"/>
    <a:srgbClr val="883466"/>
    <a:srgbClr val="271884"/>
    <a:srgbClr val="CCD2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453" autoAdjust="0"/>
    <p:restoredTop sz="96723" autoAdjust="0"/>
  </p:normalViewPr>
  <p:slideViewPr>
    <p:cSldViewPr snapToGrid="0" snapToObjects="1">
      <p:cViewPr varScale="1">
        <p:scale>
          <a:sx n="68" d="100"/>
          <a:sy n="68" d="100"/>
        </p:scale>
        <p:origin x="858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swnas\urology\Raj%20Lab\Shihong%20Ma\Aparna%20Alluri%202018%20summer\070918%20mcf7%20t47d%2072h%20fig%202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\\swnas\urology\Raj%20Lab\Shihong%20Ma\Aparna%20Alluri%202018%20summer\MCF7%20T47D%20exp%20%23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050" b="1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223732934545972"/>
          <c:y val="8.6142943231383218E-2"/>
          <c:w val="0.84453267639040397"/>
          <c:h val="0.52558974239376199"/>
        </c:manualLayout>
      </c:layout>
      <c:barChart>
        <c:barDir val="col"/>
        <c:grouping val="clustered"/>
        <c:varyColors val="0"/>
        <c:ser>
          <c:idx val="5"/>
          <c:order val="0"/>
          <c:tx>
            <c:strRef>
              <c:f>'mcf7 p1'!$B$48</c:f>
              <c:strCache>
                <c:ptCount val="1"/>
                <c:pt idx="0">
                  <c:v>MCF-7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2B1A92"/>
              </a:solidFill>
              <a:ln>
                <a:solidFill>
                  <a:srgbClr val="2B1A92"/>
                </a:solidFill>
              </a:ln>
            </c:spPr>
            <c:extLst>
              <c:ext xmlns:c16="http://schemas.microsoft.com/office/drawing/2014/chart" uri="{C3380CC4-5D6E-409C-BE32-E72D297353CC}">
                <c16:uniqueId val="{00000000-471C-45D1-B78C-762029CFCCEE}"/>
              </c:ext>
            </c:extLst>
          </c:dPt>
          <c:dPt>
            <c:idx val="1"/>
            <c:invertIfNegative val="0"/>
            <c:bubble3D val="0"/>
            <c:spPr>
              <a:solidFill>
                <a:srgbClr val="87355A"/>
              </a:solidFill>
              <a:ln>
                <a:solidFill>
                  <a:srgbClr val="87355A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71C-45D1-B78C-762029CFCCEE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D799-42D6-B82E-E950E6FB77EC}"/>
              </c:ext>
            </c:extLst>
          </c:dPt>
          <c:dPt>
            <c:idx val="4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D799-42D6-B82E-E950E6FB77EC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D799-42D6-B82E-E950E6FB77EC}"/>
              </c:ext>
            </c:extLst>
          </c:dPt>
          <c:dPt>
            <c:idx val="7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D799-42D6-B82E-E950E6FB77EC}"/>
              </c:ext>
            </c:extLst>
          </c:dPt>
          <c:errBars>
            <c:errBarType val="both"/>
            <c:errValType val="cust"/>
            <c:noEndCap val="0"/>
            <c:plus>
              <c:numRef>
                <c:f>'mcf7 p1'!$C$86:$C$93</c:f>
                <c:numCache>
                  <c:formatCode>General</c:formatCode>
                  <c:ptCount val="8"/>
                  <c:pt idx="0">
                    <c:v>3.4203178959664826</c:v>
                  </c:pt>
                  <c:pt idx="1">
                    <c:v>3.5659118958563161</c:v>
                  </c:pt>
                  <c:pt idx="2">
                    <c:v>2.7448363906558164</c:v>
                  </c:pt>
                  <c:pt idx="3">
                    <c:v>0.77564546711576665</c:v>
                  </c:pt>
                  <c:pt idx="4">
                    <c:v>0.54288050249337527</c:v>
                  </c:pt>
                  <c:pt idx="5">
                    <c:v>0.96545898619413384</c:v>
                  </c:pt>
                  <c:pt idx="6">
                    <c:v>2.9479713843138016</c:v>
                  </c:pt>
                  <c:pt idx="7">
                    <c:v>0.444288304246161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mcf7 p1'!$A$86:$A$93</c:f>
              <c:strCache>
                <c:ptCount val="8"/>
                <c:pt idx="0">
                  <c:v>Vehicle</c:v>
                </c:pt>
                <c:pt idx="1">
                  <c:v>ERX-11</c:v>
                </c:pt>
                <c:pt idx="2">
                  <c:v>Cisplatin</c:v>
                </c:pt>
                <c:pt idx="3">
                  <c:v>Nab-Paclitaxel</c:v>
                </c:pt>
                <c:pt idx="4">
                  <c:v>Gemcitabine</c:v>
                </c:pt>
                <c:pt idx="5">
                  <c:v>ERX-11+Cisplatin</c:v>
                </c:pt>
                <c:pt idx="6">
                  <c:v>ERX-11+Nab-Paclitaxel</c:v>
                </c:pt>
                <c:pt idx="7">
                  <c:v>ERX-11 1uM+Gemcitabine</c:v>
                </c:pt>
              </c:strCache>
            </c:strRef>
          </c:cat>
          <c:val>
            <c:numRef>
              <c:f>'mcf7 p1'!$B$86:$B$93</c:f>
              <c:numCache>
                <c:formatCode>General</c:formatCode>
                <c:ptCount val="8"/>
                <c:pt idx="0">
                  <c:v>99.318150299705692</c:v>
                </c:pt>
                <c:pt idx="1">
                  <c:v>61.778279427400349</c:v>
                </c:pt>
                <c:pt idx="2">
                  <c:v>40.719139559609843</c:v>
                </c:pt>
                <c:pt idx="3">
                  <c:v>17.43763193984314</c:v>
                </c:pt>
                <c:pt idx="4">
                  <c:v>12.569533260397245</c:v>
                </c:pt>
                <c:pt idx="5">
                  <c:v>38.015239533414494</c:v>
                </c:pt>
                <c:pt idx="6">
                  <c:v>17.594033622509517</c:v>
                </c:pt>
                <c:pt idx="7">
                  <c:v>14.6728662341864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02-421B-9FCC-44C4B16037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951552"/>
        <c:axId val="78953088"/>
      </c:barChart>
      <c:catAx>
        <c:axId val="78951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/>
            </a:pPr>
            <a:endParaRPr lang="en-US"/>
          </a:p>
        </c:txPr>
        <c:crossAx val="78953088"/>
        <c:crosses val="autoZero"/>
        <c:auto val="1"/>
        <c:lblAlgn val="ctr"/>
        <c:lblOffset val="100"/>
        <c:noMultiLvlLbl val="0"/>
      </c:catAx>
      <c:valAx>
        <c:axId val="78953088"/>
        <c:scaling>
          <c:orientation val="minMax"/>
          <c:max val="120"/>
        </c:scaling>
        <c:delete val="0"/>
        <c:axPos val="l"/>
        <c:title>
          <c:tx>
            <c:rich>
              <a:bodyPr/>
              <a:lstStyle/>
              <a:p>
                <a:pPr>
                  <a:defRPr sz="1000" b="1"/>
                </a:pPr>
                <a:r>
                  <a:rPr lang="en-US" sz="1000" b="1" dirty="0"/>
                  <a:t>% cell viabil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/>
            </a:pPr>
            <a:endParaRPr lang="en-US"/>
          </a:p>
        </c:txPr>
        <c:crossAx val="78951552"/>
        <c:crosses val="autoZero"/>
        <c:crossBetween val="between"/>
        <c:majorUnit val="30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 b="1"/>
            </a:pPr>
            <a:r>
              <a:rPr lang="en-US" sz="1050" b="1"/>
              <a:t>T-47D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55467323609596"/>
          <c:y val="8.8680370485064539E-2"/>
          <c:w val="0.84453267639040397"/>
          <c:h val="0.51885479003036283"/>
        </c:manualLayout>
      </c:layout>
      <c:barChart>
        <c:barDir val="col"/>
        <c:grouping val="clustered"/>
        <c:varyColors val="0"/>
        <c:ser>
          <c:idx val="5"/>
          <c:order val="0"/>
          <c:tx>
            <c:strRef>
              <c:f>'mcf7 p1'!$J$210</c:f>
              <c:strCache>
                <c:ptCount val="1"/>
                <c:pt idx="0">
                  <c:v>T47D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2B1A92"/>
              </a:solidFill>
              <a:ln>
                <a:solidFill>
                  <a:srgbClr val="2B1A92"/>
                </a:solidFill>
              </a:ln>
            </c:spPr>
            <c:extLst>
              <c:ext xmlns:c16="http://schemas.microsoft.com/office/drawing/2014/chart" uri="{C3380CC4-5D6E-409C-BE32-E72D297353CC}">
                <c16:uniqueId val="{00000000-AC40-4231-AA48-6387E8A07FC3}"/>
              </c:ext>
            </c:extLst>
          </c:dPt>
          <c:dPt>
            <c:idx val="1"/>
            <c:invertIfNegative val="0"/>
            <c:bubble3D val="0"/>
            <c:spPr>
              <a:solidFill>
                <a:srgbClr val="87355A"/>
              </a:solidFill>
              <a:ln>
                <a:solidFill>
                  <a:srgbClr val="87355A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C40-4231-AA48-6387E8A07FC3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146-471F-8D3B-CA751C68A230}"/>
              </c:ext>
            </c:extLst>
          </c:dPt>
          <c:dPt>
            <c:idx val="4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6146-471F-8D3B-CA751C68A230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6146-471F-8D3B-CA751C68A230}"/>
              </c:ext>
            </c:extLst>
          </c:dPt>
          <c:dPt>
            <c:idx val="7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6146-471F-8D3B-CA751C68A230}"/>
              </c:ext>
            </c:extLst>
          </c:dPt>
          <c:errBars>
            <c:errBarType val="both"/>
            <c:errValType val="cust"/>
            <c:noEndCap val="0"/>
            <c:plus>
              <c:numRef>
                <c:f>'mcf7 p1'!$K$213:$K$220</c:f>
                <c:numCache>
                  <c:formatCode>General</c:formatCode>
                  <c:ptCount val="8"/>
                  <c:pt idx="0">
                    <c:v>4.2388793322961176</c:v>
                  </c:pt>
                  <c:pt idx="1">
                    <c:v>13.588464158981919</c:v>
                  </c:pt>
                  <c:pt idx="2">
                    <c:v>10.733039049253289</c:v>
                  </c:pt>
                  <c:pt idx="3">
                    <c:v>10.362505668757505</c:v>
                  </c:pt>
                  <c:pt idx="4">
                    <c:v>6.4833463358287799</c:v>
                  </c:pt>
                  <c:pt idx="5">
                    <c:v>16.775304138734086</c:v>
                  </c:pt>
                  <c:pt idx="6">
                    <c:v>5.9083640684468621</c:v>
                  </c:pt>
                  <c:pt idx="7">
                    <c:v>13.6116763788482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mcf7 p1'!$G$213:$G$220</c:f>
              <c:strCache>
                <c:ptCount val="8"/>
                <c:pt idx="0">
                  <c:v>Vehicle</c:v>
                </c:pt>
                <c:pt idx="1">
                  <c:v>ERX-11</c:v>
                </c:pt>
                <c:pt idx="2">
                  <c:v>Cisplatin</c:v>
                </c:pt>
                <c:pt idx="3">
                  <c:v>Nab-Paclitaxel</c:v>
                </c:pt>
                <c:pt idx="4">
                  <c:v>Gemcitabine</c:v>
                </c:pt>
                <c:pt idx="5">
                  <c:v>ERX-11+Cisplatin</c:v>
                </c:pt>
                <c:pt idx="6">
                  <c:v>ERX-11+Nab-Paclitaxel</c:v>
                </c:pt>
                <c:pt idx="7">
                  <c:v>ERX-11 1uM+Gemcitabine</c:v>
                </c:pt>
              </c:strCache>
            </c:strRef>
          </c:cat>
          <c:val>
            <c:numRef>
              <c:f>'mcf7 p1'!$J$213:$J$220</c:f>
              <c:numCache>
                <c:formatCode>General</c:formatCode>
                <c:ptCount val="8"/>
                <c:pt idx="0">
                  <c:v>100</c:v>
                </c:pt>
                <c:pt idx="1">
                  <c:v>59.23362592842674</c:v>
                </c:pt>
                <c:pt idx="2">
                  <c:v>74.02400098213738</c:v>
                </c:pt>
                <c:pt idx="3">
                  <c:v>48.769259100116635</c:v>
                </c:pt>
                <c:pt idx="4">
                  <c:v>46.990669694923582</c:v>
                </c:pt>
                <c:pt idx="5">
                  <c:v>67.782824872629064</c:v>
                </c:pt>
                <c:pt idx="6">
                  <c:v>52.042538825118164</c:v>
                </c:pt>
                <c:pt idx="7">
                  <c:v>54.243140384261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72-4CF3-8648-19590B6884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0173312"/>
        <c:axId val="140174848"/>
      </c:barChart>
      <c:catAx>
        <c:axId val="1401733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/>
            </a:pPr>
            <a:endParaRPr lang="en-US"/>
          </a:p>
        </c:txPr>
        <c:crossAx val="140174848"/>
        <c:crosses val="autoZero"/>
        <c:auto val="1"/>
        <c:lblAlgn val="ctr"/>
        <c:lblOffset val="100"/>
        <c:noMultiLvlLbl val="0"/>
      </c:catAx>
      <c:valAx>
        <c:axId val="140174848"/>
        <c:scaling>
          <c:orientation val="minMax"/>
          <c:max val="120"/>
        </c:scaling>
        <c:delete val="0"/>
        <c:axPos val="l"/>
        <c:title>
          <c:tx>
            <c:rich>
              <a:bodyPr/>
              <a:lstStyle/>
              <a:p>
                <a:pPr>
                  <a:defRPr sz="1000" b="1"/>
                </a:pPr>
                <a:r>
                  <a:rPr lang="en-US" sz="1000" b="1"/>
                  <a:t>% cell viabil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/>
            </a:pPr>
            <a:endParaRPr lang="en-US"/>
          </a:p>
        </c:txPr>
        <c:crossAx val="140173312"/>
        <c:crosses val="autoZero"/>
        <c:crossBetween val="between"/>
        <c:majorUnit val="30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6249</cdr:x>
      <cdr:y>0.2769</cdr:y>
    </cdr:from>
    <cdr:to>
      <cdr:x>0.36509</cdr:x>
      <cdr:y>0.33884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032072" y="961715"/>
          <a:ext cx="403415" cy="2151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000" dirty="0">
              <a:latin typeface="Arial" panose="020B0604020202020204" pitchFamily="34" charset="0"/>
              <a:cs typeface="Arial" panose="020B0604020202020204" pitchFamily="34" charset="0"/>
            </a:rPr>
            <a:t>****</a:t>
          </a:r>
        </a:p>
      </cdr:txBody>
    </cdr:sp>
  </cdr:relSizeAnchor>
  <cdr:relSizeAnchor xmlns:cdr="http://schemas.openxmlformats.org/drawingml/2006/chartDrawing">
    <cdr:from>
      <cdr:x>0.5794</cdr:x>
      <cdr:y>0.49114</cdr:y>
    </cdr:from>
    <cdr:to>
      <cdr:x>0.682</cdr:x>
      <cdr:y>0.55309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278162" y="1705801"/>
          <a:ext cx="403415" cy="2151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>
              <a:latin typeface="Arial" panose="020B0604020202020204" pitchFamily="34" charset="0"/>
              <a:cs typeface="Arial" panose="020B0604020202020204" pitchFamily="34" charset="0"/>
            </a:rPr>
            <a:t>****</a:t>
          </a:r>
        </a:p>
      </cdr:txBody>
    </cdr:sp>
  </cdr:relSizeAnchor>
  <cdr:relSizeAnchor xmlns:cdr="http://schemas.openxmlformats.org/drawingml/2006/chartDrawing">
    <cdr:from>
      <cdr:x>0.78964</cdr:x>
      <cdr:y>0.46932</cdr:y>
    </cdr:from>
    <cdr:to>
      <cdr:x>0.89223</cdr:x>
      <cdr:y>0.53127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3104789" y="1630044"/>
          <a:ext cx="403376" cy="2151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>
              <a:latin typeface="Arial" panose="020B0604020202020204" pitchFamily="34" charset="0"/>
              <a:cs typeface="Arial" panose="020B0604020202020204" pitchFamily="34" charset="0"/>
            </a:rPr>
            <a:t>***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6281</cdr:x>
      <cdr:y>0.24498</cdr:y>
    </cdr:from>
    <cdr:to>
      <cdr:x>0.36439</cdr:x>
      <cdr:y>0.3060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043679" y="863095"/>
          <a:ext cx="403390" cy="2151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>
              <a:latin typeface="Arial" panose="020B0604020202020204" pitchFamily="34" charset="0"/>
              <a:cs typeface="Arial" panose="020B0604020202020204" pitchFamily="34" charset="0"/>
            </a:rPr>
            <a:t>***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88C7DB-B5A3-4858-A01E-8A91CB655C16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0152E5-8FBE-4331-834E-9C636BF4E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4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415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384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580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69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578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380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203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669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920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972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290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101D3D-0748-8B44-9CC0-C4742B0D2A91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3F050-6BB4-E740-9B35-6FA69D330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623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3" Type="http://schemas.openxmlformats.org/officeDocument/2006/relationships/image" Target="../media/image9.png"/><Relationship Id="rId7" Type="http://schemas.openxmlformats.org/officeDocument/2006/relationships/image" Target="../media/image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Relationship Id="rId9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eg"/><Relationship Id="rId13" Type="http://schemas.microsoft.com/office/2007/relationships/hdphoto" Target="../media/hdphoto2.wdp"/><Relationship Id="rId3" Type="http://schemas.openxmlformats.org/officeDocument/2006/relationships/image" Target="../media/image16.png"/><Relationship Id="rId7" Type="http://schemas.openxmlformats.org/officeDocument/2006/relationships/image" Target="../media/image19.jpeg"/><Relationship Id="rId12" Type="http://schemas.openxmlformats.org/officeDocument/2006/relationships/image" Target="../media/image24.pn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jpeg"/><Relationship Id="rId11" Type="http://schemas.openxmlformats.org/officeDocument/2006/relationships/image" Target="../media/image23.png"/><Relationship Id="rId5" Type="http://schemas.openxmlformats.org/officeDocument/2006/relationships/image" Target="../media/image17.jpeg"/><Relationship Id="rId10" Type="http://schemas.openxmlformats.org/officeDocument/2006/relationships/image" Target="../media/image22.png"/><Relationship Id="rId4" Type="http://schemas.microsoft.com/office/2007/relationships/hdphoto" Target="../media/hdphoto1.wdp"/><Relationship Id="rId9" Type="http://schemas.openxmlformats.org/officeDocument/2006/relationships/image" Target="../media/image21.jpeg"/><Relationship Id="rId14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hyperlink" Target="https://reactome.org/" TargetMode="External"/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eg"/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jpeg"/><Relationship Id="rId5" Type="http://schemas.openxmlformats.org/officeDocument/2006/relationships/image" Target="../media/image30.jpeg"/><Relationship Id="rId4" Type="http://schemas.openxmlformats.org/officeDocument/2006/relationships/image" Target="../media/image2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7056" y="431621"/>
            <a:ext cx="8274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3420079-0DBE-4D89-A8C0-499BE61ABE15}"/>
              </a:ext>
            </a:extLst>
          </p:cNvPr>
          <p:cNvSpPr txBox="1"/>
          <p:nvPr/>
        </p:nvSpPr>
        <p:spPr>
          <a:xfrm>
            <a:off x="530090" y="12121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5D6D390-005E-4710-BE98-6279C589A760}"/>
              </a:ext>
            </a:extLst>
          </p:cNvPr>
          <p:cNvSpPr txBox="1"/>
          <p:nvPr/>
        </p:nvSpPr>
        <p:spPr>
          <a:xfrm>
            <a:off x="4462010" y="12121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586180" y="1620732"/>
            <a:ext cx="3931920" cy="3473169"/>
            <a:chOff x="530090" y="1595787"/>
            <a:chExt cx="3931920" cy="3473169"/>
          </a:xfrm>
        </p:grpSpPr>
        <p:grpSp>
          <p:nvGrpSpPr>
            <p:cNvPr id="2" name="Group 1"/>
            <p:cNvGrpSpPr/>
            <p:nvPr/>
          </p:nvGrpSpPr>
          <p:grpSpPr>
            <a:xfrm>
              <a:off x="530090" y="1595787"/>
              <a:ext cx="3931920" cy="3473169"/>
              <a:chOff x="530090" y="1595787"/>
              <a:chExt cx="3931920" cy="3473169"/>
            </a:xfrm>
          </p:grpSpPr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id="{00000000-0008-0000-0000-00000200000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299996908"/>
                  </p:ext>
                </p:extLst>
              </p:nvPr>
            </p:nvGraphicFramePr>
            <p:xfrm>
              <a:off x="530090" y="1595787"/>
              <a:ext cx="3931920" cy="347316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8" name="TextBox 1"/>
              <p:cNvSpPr txBox="1"/>
              <p:nvPr/>
            </p:nvSpPr>
            <p:spPr>
              <a:xfrm>
                <a:off x="1973811" y="2877066"/>
                <a:ext cx="403412" cy="215153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sp>
            <p:nvSpPr>
              <p:cNvPr id="9" name="TextBox 1"/>
              <p:cNvSpPr txBox="1"/>
              <p:nvPr/>
            </p:nvSpPr>
            <p:spPr>
              <a:xfrm>
                <a:off x="2385461" y="3255886"/>
                <a:ext cx="403412" cy="215153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sp>
            <p:nvSpPr>
              <p:cNvPr id="10" name="TextBox 1"/>
              <p:cNvSpPr txBox="1"/>
              <p:nvPr/>
            </p:nvSpPr>
            <p:spPr>
              <a:xfrm>
                <a:off x="3219905" y="2941271"/>
                <a:ext cx="403412" cy="215153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sp>
            <p:nvSpPr>
              <p:cNvPr id="13" name="TextBox 1"/>
              <p:cNvSpPr txBox="1"/>
              <p:nvPr/>
            </p:nvSpPr>
            <p:spPr>
              <a:xfrm>
                <a:off x="4038255" y="3281082"/>
                <a:ext cx="403412" cy="215153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2146856" y="2021428"/>
              <a:ext cx="2179981" cy="1280160"/>
              <a:chOff x="2146856" y="2021428"/>
              <a:chExt cx="2179981" cy="1280160"/>
            </a:xfrm>
          </p:grpSpPr>
          <p:cxnSp>
            <p:nvCxnSpPr>
              <p:cNvPr id="20" name="Straight Connector 19"/>
              <p:cNvCxnSpPr/>
              <p:nvPr/>
            </p:nvCxnSpPr>
            <p:spPr>
              <a:xfrm>
                <a:off x="2146856" y="2724823"/>
                <a:ext cx="9144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>
                <a:off x="3412437" y="2726148"/>
                <a:ext cx="9144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Left Bracket 22"/>
              <p:cNvSpPr/>
              <p:nvPr/>
            </p:nvSpPr>
            <p:spPr>
              <a:xfrm>
                <a:off x="3193320" y="2021428"/>
                <a:ext cx="111318" cy="128016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  <a:scene3d>
                <a:camera prst="orthographicFront">
                  <a:rot lat="0" lon="0" rev="16200000"/>
                </a:camera>
                <a:lightRig rig="threePt" dir="t"/>
              </a:scene3d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3057515" y="2374503"/>
                <a:ext cx="31931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>
                  <a:defRPr sz="132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/>
                  <a:t>ns</a:t>
                </a:r>
              </a:p>
            </p:txBody>
          </p:sp>
        </p:grpSp>
      </p:grpSp>
      <p:grpSp>
        <p:nvGrpSpPr>
          <p:cNvPr id="34" name="Group 33"/>
          <p:cNvGrpSpPr/>
          <p:nvPr/>
        </p:nvGrpSpPr>
        <p:grpSpPr>
          <a:xfrm>
            <a:off x="4571999" y="1490016"/>
            <a:ext cx="3971161" cy="3628830"/>
            <a:chOff x="4571999" y="1490016"/>
            <a:chExt cx="3971161" cy="3628830"/>
          </a:xfrm>
        </p:grpSpPr>
        <p:grpSp>
          <p:nvGrpSpPr>
            <p:cNvPr id="3" name="Group 2"/>
            <p:cNvGrpSpPr/>
            <p:nvPr/>
          </p:nvGrpSpPr>
          <p:grpSpPr>
            <a:xfrm>
              <a:off x="4571999" y="1595789"/>
              <a:ext cx="3971161" cy="3523057"/>
              <a:chOff x="4571999" y="1595789"/>
              <a:chExt cx="3971161" cy="3523057"/>
            </a:xfrm>
          </p:grpSpPr>
          <p:sp>
            <p:nvSpPr>
              <p:cNvPr id="14" name="TextBox 1"/>
              <p:cNvSpPr txBox="1"/>
              <p:nvPr/>
            </p:nvSpPr>
            <p:spPr>
              <a:xfrm>
                <a:off x="6010835" y="2178424"/>
                <a:ext cx="403412" cy="255494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sp>
            <p:nvSpPr>
              <p:cNvPr id="15" name="TextBox 1"/>
              <p:cNvSpPr txBox="1"/>
              <p:nvPr/>
            </p:nvSpPr>
            <p:spPr>
              <a:xfrm>
                <a:off x="6432177" y="2559426"/>
                <a:ext cx="403412" cy="255494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sp>
            <p:nvSpPr>
              <p:cNvPr id="16" name="TextBox 1"/>
              <p:cNvSpPr txBox="1"/>
              <p:nvPr/>
            </p:nvSpPr>
            <p:spPr>
              <a:xfrm>
                <a:off x="6871449" y="2640110"/>
                <a:ext cx="403412" cy="255494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sp>
            <p:nvSpPr>
              <p:cNvPr id="17" name="TextBox 1"/>
              <p:cNvSpPr txBox="1"/>
              <p:nvPr/>
            </p:nvSpPr>
            <p:spPr>
              <a:xfrm>
                <a:off x="7301755" y="2182911"/>
                <a:ext cx="403412" cy="255494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8" name="TextBox 1"/>
              <p:cNvSpPr txBox="1"/>
              <p:nvPr/>
            </p:nvSpPr>
            <p:spPr>
              <a:xfrm>
                <a:off x="7687237" y="2568394"/>
                <a:ext cx="403412" cy="255494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sp>
            <p:nvSpPr>
              <p:cNvPr id="19" name="TextBox 1"/>
              <p:cNvSpPr txBox="1"/>
              <p:nvPr/>
            </p:nvSpPr>
            <p:spPr>
              <a:xfrm>
                <a:off x="8108578" y="2424958"/>
                <a:ext cx="403412" cy="255494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graphicFrame>
            <p:nvGraphicFramePr>
              <p:cNvPr id="21" name="Chart 20">
                <a:extLst>
                  <a:ext uri="{FF2B5EF4-FFF2-40B4-BE49-F238E27FC236}">
                    <a16:creationId xmlns:a16="http://schemas.microsoft.com/office/drawing/2014/main" id="{00000000-0008-0000-0000-00000200000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75879579"/>
                  </p:ext>
                </p:extLst>
              </p:nvPr>
            </p:nvGraphicFramePr>
            <p:xfrm>
              <a:off x="4571999" y="1595789"/>
              <a:ext cx="3971161" cy="352305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grpSp>
          <p:nvGrpSpPr>
            <p:cNvPr id="35" name="Group 34"/>
            <p:cNvGrpSpPr/>
            <p:nvPr/>
          </p:nvGrpSpPr>
          <p:grpSpPr>
            <a:xfrm>
              <a:off x="6195397" y="1490016"/>
              <a:ext cx="2179981" cy="1280160"/>
              <a:chOff x="2146856" y="2021428"/>
              <a:chExt cx="2179981" cy="1280160"/>
            </a:xfrm>
          </p:grpSpPr>
          <p:cxnSp>
            <p:nvCxnSpPr>
              <p:cNvPr id="36" name="Straight Connector 35"/>
              <p:cNvCxnSpPr/>
              <p:nvPr/>
            </p:nvCxnSpPr>
            <p:spPr>
              <a:xfrm>
                <a:off x="2146856" y="2724823"/>
                <a:ext cx="9144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3412437" y="2726148"/>
                <a:ext cx="9144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Left Bracket 37"/>
              <p:cNvSpPr/>
              <p:nvPr/>
            </p:nvSpPr>
            <p:spPr>
              <a:xfrm>
                <a:off x="3193320" y="2021428"/>
                <a:ext cx="111318" cy="128016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  <a:scene3d>
                <a:camera prst="orthographicFront">
                  <a:rot lat="0" lon="0" rev="16200000"/>
                </a:camera>
                <a:lightRig rig="threePt" dir="t"/>
              </a:scene3d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3057515" y="2349789"/>
                <a:ext cx="31931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>
                  <a:defRPr sz="132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</p:grpSp>
      </p:grpSp>
      <p:sp>
        <p:nvSpPr>
          <p:cNvPr id="6" name="Rectangle 5"/>
          <p:cNvSpPr/>
          <p:nvPr/>
        </p:nvSpPr>
        <p:spPr>
          <a:xfrm>
            <a:off x="1714093" y="5865501"/>
            <a:ext cx="193995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**,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&lt;0.005, ****,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&lt;0.0001.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0621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745822" y="2354570"/>
            <a:ext cx="1851102" cy="2937619"/>
            <a:chOff x="3419708" y="2188225"/>
            <a:chExt cx="1851102" cy="2937619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64C2BD6-2EC3-4EB7-80D8-9BBD9F4DD80B}"/>
                </a:ext>
              </a:extLst>
            </p:cNvPr>
            <p:cNvSpPr txBox="1"/>
            <p:nvPr/>
          </p:nvSpPr>
          <p:spPr>
            <a:xfrm>
              <a:off x="3884697" y="2188225"/>
              <a:ext cx="774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lbo</a:t>
              </a:r>
              <a:endParaRPr lang="en-US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3569582" y="3498059"/>
              <a:ext cx="1476710" cy="1269079"/>
              <a:chOff x="3513825" y="2059552"/>
              <a:chExt cx="1476710" cy="1269079"/>
            </a:xfrm>
          </p:grpSpPr>
          <p:sp>
            <p:nvSpPr>
              <p:cNvPr id="16" name="Oval 15"/>
              <p:cNvSpPr/>
              <p:nvPr/>
            </p:nvSpPr>
            <p:spPr>
              <a:xfrm>
                <a:off x="4239311" y="2410968"/>
                <a:ext cx="412394" cy="109728"/>
              </a:xfrm>
              <a:prstGeom prst="ellipse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8" name="Pie 37">
                <a:extLst>
                  <a:ext uri="{FF2B5EF4-FFF2-40B4-BE49-F238E27FC236}">
                    <a16:creationId xmlns:a16="http://schemas.microsoft.com/office/drawing/2014/main" id="{03DA4054-2476-4D03-90F4-7554F19CDE6D}"/>
                  </a:ext>
                </a:extLst>
              </p:cNvPr>
              <p:cNvSpPr/>
              <p:nvPr/>
            </p:nvSpPr>
            <p:spPr>
              <a:xfrm>
                <a:off x="3860416" y="2331165"/>
                <a:ext cx="737788" cy="655302"/>
              </a:xfrm>
              <a:prstGeom prst="pie">
                <a:avLst/>
              </a:prstGeom>
              <a:solidFill>
                <a:schemeClr val="accent2">
                  <a:lumMod val="40000"/>
                  <a:lumOff val="60000"/>
                  <a:alpha val="33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ounded Rectangle 22">
                <a:extLst>
                  <a:ext uri="{FF2B5EF4-FFF2-40B4-BE49-F238E27FC236}">
                    <a16:creationId xmlns:a16="http://schemas.microsoft.com/office/drawing/2014/main" id="{F11AAA42-44D6-4856-A994-2C4A29A83AEE}"/>
                  </a:ext>
                </a:extLst>
              </p:cNvPr>
              <p:cNvSpPr/>
              <p:nvPr/>
            </p:nvSpPr>
            <p:spPr>
              <a:xfrm>
                <a:off x="3860415" y="2059552"/>
                <a:ext cx="412035" cy="337065"/>
              </a:xfrm>
              <a:prstGeom prst="roundRect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1</a:t>
                </a:r>
              </a:p>
            </p:txBody>
          </p:sp>
          <p:sp>
            <p:nvSpPr>
              <p:cNvPr id="10" name="Rounded Rectangle 22">
                <a:extLst>
                  <a:ext uri="{FF2B5EF4-FFF2-40B4-BE49-F238E27FC236}">
                    <a16:creationId xmlns:a16="http://schemas.microsoft.com/office/drawing/2014/main" id="{2341C2D4-910D-4551-8521-AED96E5CD072}"/>
                  </a:ext>
                </a:extLst>
              </p:cNvPr>
              <p:cNvSpPr/>
              <p:nvPr/>
            </p:nvSpPr>
            <p:spPr>
              <a:xfrm>
                <a:off x="3513825" y="2453715"/>
                <a:ext cx="412035" cy="337065"/>
              </a:xfrm>
              <a:prstGeom prst="roundRect">
                <a:avLst/>
              </a:prstGeom>
              <a:solidFill>
                <a:schemeClr val="accent3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2</a:t>
                </a:r>
              </a:p>
            </p:txBody>
          </p:sp>
          <p:sp>
            <p:nvSpPr>
              <p:cNvPr id="11" name="Rounded Rectangle 22">
                <a:extLst>
                  <a:ext uri="{FF2B5EF4-FFF2-40B4-BE49-F238E27FC236}">
                    <a16:creationId xmlns:a16="http://schemas.microsoft.com/office/drawing/2014/main" id="{267998AF-D9BC-40CC-AF8A-FDE6A6ACAFB4}"/>
                  </a:ext>
                </a:extLst>
              </p:cNvPr>
              <p:cNvSpPr/>
              <p:nvPr/>
            </p:nvSpPr>
            <p:spPr>
              <a:xfrm>
                <a:off x="3687120" y="2938944"/>
                <a:ext cx="412035" cy="337065"/>
              </a:xfrm>
              <a:prstGeom prst="roundRect">
                <a:avLst/>
              </a:prstGeom>
              <a:solidFill>
                <a:srgbClr val="FFC000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3</a:t>
                </a:r>
              </a:p>
            </p:txBody>
          </p:sp>
          <p:sp>
            <p:nvSpPr>
              <p:cNvPr id="12" name="Rounded Rectangle 22">
                <a:extLst>
                  <a:ext uri="{FF2B5EF4-FFF2-40B4-BE49-F238E27FC236}">
                    <a16:creationId xmlns:a16="http://schemas.microsoft.com/office/drawing/2014/main" id="{CE5DA2A8-F6C1-45FC-8FF4-6248334B02A3}"/>
                  </a:ext>
                </a:extLst>
              </p:cNvPr>
              <p:cNvSpPr/>
              <p:nvPr/>
            </p:nvSpPr>
            <p:spPr>
              <a:xfrm>
                <a:off x="4241872" y="2991566"/>
                <a:ext cx="412035" cy="337065"/>
              </a:xfrm>
              <a:prstGeom prst="roundRect">
                <a:avLst/>
              </a:prstGeom>
              <a:solidFill>
                <a:srgbClr val="00B0F0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4</a:t>
                </a:r>
              </a:p>
            </p:txBody>
          </p:sp>
          <p:sp>
            <p:nvSpPr>
              <p:cNvPr id="13" name="Rounded Rectangle 22">
                <a:extLst>
                  <a:ext uri="{FF2B5EF4-FFF2-40B4-BE49-F238E27FC236}">
                    <a16:creationId xmlns:a16="http://schemas.microsoft.com/office/drawing/2014/main" id="{0774229A-6CF2-4449-8A38-FD08FBDCFE2D}"/>
                  </a:ext>
                </a:extLst>
              </p:cNvPr>
              <p:cNvSpPr/>
              <p:nvPr/>
            </p:nvSpPr>
            <p:spPr>
              <a:xfrm>
                <a:off x="4578500" y="2681813"/>
                <a:ext cx="412035" cy="337065"/>
              </a:xfrm>
              <a:prstGeom prst="roundRect">
                <a:avLst/>
              </a:prstGeom>
              <a:solidFill>
                <a:schemeClr val="accent6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5</a:t>
                </a:r>
              </a:p>
            </p:txBody>
          </p:sp>
        </p:grpSp>
        <p:sp>
          <p:nvSpPr>
            <p:cNvPr id="7" name="Rounded Rectangle 6"/>
            <p:cNvSpPr/>
            <p:nvPr/>
          </p:nvSpPr>
          <p:spPr>
            <a:xfrm>
              <a:off x="3419708" y="2215476"/>
              <a:ext cx="1851102" cy="2910368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6751533" y="2352044"/>
            <a:ext cx="1851102" cy="2940145"/>
            <a:chOff x="5898995" y="2141094"/>
            <a:chExt cx="1851102" cy="2940145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EAFDB0D-1318-4297-86F0-3C4B255171DC}"/>
                </a:ext>
              </a:extLst>
            </p:cNvPr>
            <p:cNvSpPr txBox="1"/>
            <p:nvPr/>
          </p:nvSpPr>
          <p:spPr>
            <a:xfrm>
              <a:off x="5976696" y="2141094"/>
              <a:ext cx="17000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X-11+Palbo</a:t>
              </a: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6078344" y="3382829"/>
              <a:ext cx="1476710" cy="1310226"/>
              <a:chOff x="5621144" y="2044683"/>
              <a:chExt cx="1476710" cy="1310226"/>
            </a:xfrm>
          </p:grpSpPr>
          <p:sp>
            <p:nvSpPr>
              <p:cNvPr id="28" name="Oval 27"/>
              <p:cNvSpPr/>
              <p:nvPr/>
            </p:nvSpPr>
            <p:spPr>
              <a:xfrm>
                <a:off x="6333287" y="2447544"/>
                <a:ext cx="412394" cy="109728"/>
              </a:xfrm>
              <a:prstGeom prst="ellipse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21" name="Pie 37">
                <a:extLst>
                  <a:ext uri="{FF2B5EF4-FFF2-40B4-BE49-F238E27FC236}">
                    <a16:creationId xmlns:a16="http://schemas.microsoft.com/office/drawing/2014/main" id="{F031ED81-6F99-47D3-A6FB-A202F7D12C5C}"/>
                  </a:ext>
                </a:extLst>
              </p:cNvPr>
              <p:cNvSpPr/>
              <p:nvPr/>
            </p:nvSpPr>
            <p:spPr>
              <a:xfrm>
                <a:off x="5964279" y="2357443"/>
                <a:ext cx="741244" cy="655302"/>
              </a:xfrm>
              <a:prstGeom prst="pie">
                <a:avLst/>
              </a:prstGeom>
              <a:solidFill>
                <a:schemeClr val="accent2">
                  <a:lumMod val="40000"/>
                  <a:lumOff val="60000"/>
                  <a:alpha val="33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Rounded Rectangle 22">
                <a:extLst>
                  <a:ext uri="{FF2B5EF4-FFF2-40B4-BE49-F238E27FC236}">
                    <a16:creationId xmlns:a16="http://schemas.microsoft.com/office/drawing/2014/main" id="{30B06C86-41E9-4FD2-9731-35B0B7109450}"/>
                  </a:ext>
                </a:extLst>
              </p:cNvPr>
              <p:cNvSpPr/>
              <p:nvPr/>
            </p:nvSpPr>
            <p:spPr>
              <a:xfrm>
                <a:off x="5621144" y="2479993"/>
                <a:ext cx="412035" cy="337065"/>
              </a:xfrm>
              <a:prstGeom prst="roundRect">
                <a:avLst/>
              </a:prstGeom>
              <a:pattFill prst="pct50">
                <a:fgClr>
                  <a:schemeClr val="accent3"/>
                </a:fgClr>
                <a:bgClr>
                  <a:schemeClr val="bg1"/>
                </a:bgClr>
              </a:pattFill>
              <a:ln>
                <a:prstDash val="sysDot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2</a:t>
                </a:r>
              </a:p>
            </p:txBody>
          </p:sp>
          <p:sp>
            <p:nvSpPr>
              <p:cNvPr id="23" name="Rounded Rectangle 22">
                <a:extLst>
                  <a:ext uri="{FF2B5EF4-FFF2-40B4-BE49-F238E27FC236}">
                    <a16:creationId xmlns:a16="http://schemas.microsoft.com/office/drawing/2014/main" id="{ADA8E43E-CEE6-4E76-840C-8AA5DCDF718F}"/>
                  </a:ext>
                </a:extLst>
              </p:cNvPr>
              <p:cNvSpPr/>
              <p:nvPr/>
            </p:nvSpPr>
            <p:spPr>
              <a:xfrm>
                <a:off x="5794439" y="2965222"/>
                <a:ext cx="412035" cy="337065"/>
              </a:xfrm>
              <a:prstGeom prst="roundRect">
                <a:avLst/>
              </a:prstGeom>
              <a:solidFill>
                <a:srgbClr val="FFC000"/>
              </a:solidFill>
              <a:ln>
                <a:prstDash val="sysDot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3</a:t>
                </a:r>
              </a:p>
            </p:txBody>
          </p:sp>
          <p:sp>
            <p:nvSpPr>
              <p:cNvPr id="24" name="Rounded Rectangle 22">
                <a:extLst>
                  <a:ext uri="{FF2B5EF4-FFF2-40B4-BE49-F238E27FC236}">
                    <a16:creationId xmlns:a16="http://schemas.microsoft.com/office/drawing/2014/main" id="{2946437D-4FDD-4B58-825A-A152C52A43F5}"/>
                  </a:ext>
                </a:extLst>
              </p:cNvPr>
              <p:cNvSpPr/>
              <p:nvPr/>
            </p:nvSpPr>
            <p:spPr>
              <a:xfrm>
                <a:off x="6349191" y="3017844"/>
                <a:ext cx="412035" cy="337065"/>
              </a:xfrm>
              <a:prstGeom prst="roundRect">
                <a:avLst/>
              </a:prstGeom>
              <a:solidFill>
                <a:srgbClr val="00B0F0">
                  <a:alpha val="30000"/>
                </a:srgbClr>
              </a:solidFill>
              <a:ln>
                <a:prstDash val="sysDot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4</a:t>
                </a:r>
              </a:p>
            </p:txBody>
          </p:sp>
          <p:sp>
            <p:nvSpPr>
              <p:cNvPr id="25" name="Rounded Rectangle 22">
                <a:extLst>
                  <a:ext uri="{FF2B5EF4-FFF2-40B4-BE49-F238E27FC236}">
                    <a16:creationId xmlns:a16="http://schemas.microsoft.com/office/drawing/2014/main" id="{6A20C383-F39B-4981-A4F9-D4EF8A6C9D4E}"/>
                  </a:ext>
                </a:extLst>
              </p:cNvPr>
              <p:cNvSpPr/>
              <p:nvPr/>
            </p:nvSpPr>
            <p:spPr>
              <a:xfrm>
                <a:off x="6685819" y="2708091"/>
                <a:ext cx="412035" cy="337065"/>
              </a:xfrm>
              <a:prstGeom prst="roundRect">
                <a:avLst/>
              </a:prstGeom>
              <a:pattFill prst="pct50">
                <a:fgClr>
                  <a:schemeClr val="accent6">
                    <a:lumMod val="75000"/>
                  </a:schemeClr>
                </a:fgClr>
                <a:bgClr>
                  <a:schemeClr val="bg1"/>
                </a:bgClr>
              </a:pattFill>
              <a:ln>
                <a:prstDash val="sysDot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5</a:t>
                </a:r>
              </a:p>
            </p:txBody>
          </p:sp>
          <p:sp>
            <p:nvSpPr>
              <p:cNvPr id="29" name="Rounded Rectangle 22">
                <a:extLst>
                  <a:ext uri="{FF2B5EF4-FFF2-40B4-BE49-F238E27FC236}">
                    <a16:creationId xmlns:a16="http://schemas.microsoft.com/office/drawing/2014/main" id="{F11AAA42-44D6-4856-A994-2C4A29A83AEE}"/>
                  </a:ext>
                </a:extLst>
              </p:cNvPr>
              <p:cNvSpPr/>
              <p:nvPr/>
            </p:nvSpPr>
            <p:spPr>
              <a:xfrm>
                <a:off x="5964278" y="2044683"/>
                <a:ext cx="412035" cy="337065"/>
              </a:xfrm>
              <a:prstGeom prst="roundRect">
                <a:avLst/>
              </a:prstGeom>
              <a:ln>
                <a:prstDash val="sysDot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1</a:t>
                </a:r>
              </a:p>
            </p:txBody>
          </p:sp>
        </p:grpSp>
        <p:sp>
          <p:nvSpPr>
            <p:cNvPr id="20" name="Rounded Rectangle 19"/>
            <p:cNvSpPr/>
            <p:nvPr/>
          </p:nvSpPr>
          <p:spPr>
            <a:xfrm>
              <a:off x="5898995" y="2141094"/>
              <a:ext cx="1851102" cy="2940145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538035" y="2299284"/>
            <a:ext cx="1851102" cy="2992905"/>
            <a:chOff x="1126274" y="2147807"/>
            <a:chExt cx="1851102" cy="2992905"/>
          </a:xfrm>
        </p:grpSpPr>
        <p:grpSp>
          <p:nvGrpSpPr>
            <p:cNvPr id="31" name="Group 30"/>
            <p:cNvGrpSpPr/>
            <p:nvPr/>
          </p:nvGrpSpPr>
          <p:grpSpPr>
            <a:xfrm>
              <a:off x="1126274" y="2148718"/>
              <a:ext cx="1851102" cy="2991994"/>
              <a:chOff x="1449659" y="743665"/>
              <a:chExt cx="1851102" cy="2991994"/>
            </a:xfrm>
          </p:grpSpPr>
          <p:sp>
            <p:nvSpPr>
              <p:cNvPr id="39" name="Oval 38"/>
              <p:cNvSpPr/>
              <p:nvPr/>
            </p:nvSpPr>
            <p:spPr>
              <a:xfrm>
                <a:off x="2331263" y="2395728"/>
                <a:ext cx="412394" cy="109728"/>
              </a:xfrm>
              <a:prstGeom prst="ellipse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33" name="Pie 37">
                <a:extLst>
                  <a:ext uri="{FF2B5EF4-FFF2-40B4-BE49-F238E27FC236}">
                    <a16:creationId xmlns:a16="http://schemas.microsoft.com/office/drawing/2014/main" id="{DF7D2981-1200-4C35-8534-028E567293E0}"/>
                  </a:ext>
                </a:extLst>
              </p:cNvPr>
              <p:cNvSpPr/>
              <p:nvPr/>
            </p:nvSpPr>
            <p:spPr>
              <a:xfrm>
                <a:off x="1963302" y="2283867"/>
                <a:ext cx="737788" cy="655302"/>
              </a:xfrm>
              <a:prstGeom prst="pi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ounded Rectangle 22">
                <a:extLst>
                  <a:ext uri="{FF2B5EF4-FFF2-40B4-BE49-F238E27FC236}">
                    <a16:creationId xmlns:a16="http://schemas.microsoft.com/office/drawing/2014/main" id="{4A64C43C-606A-42E6-A87E-8AF649621017}"/>
                  </a:ext>
                </a:extLst>
              </p:cNvPr>
              <p:cNvSpPr/>
              <p:nvPr/>
            </p:nvSpPr>
            <p:spPr>
              <a:xfrm>
                <a:off x="1963301" y="2012254"/>
                <a:ext cx="412035" cy="337065"/>
              </a:xfrm>
              <a:prstGeom prst="roundRect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1</a:t>
                </a:r>
              </a:p>
            </p:txBody>
          </p:sp>
          <p:sp>
            <p:nvSpPr>
              <p:cNvPr id="35" name="Rounded Rectangle 22">
                <a:extLst>
                  <a:ext uri="{FF2B5EF4-FFF2-40B4-BE49-F238E27FC236}">
                    <a16:creationId xmlns:a16="http://schemas.microsoft.com/office/drawing/2014/main" id="{1A65668D-F2E6-4E70-9814-84B73F01AAEB}"/>
                  </a:ext>
                </a:extLst>
              </p:cNvPr>
              <p:cNvSpPr/>
              <p:nvPr/>
            </p:nvSpPr>
            <p:spPr>
              <a:xfrm>
                <a:off x="1616711" y="2406417"/>
                <a:ext cx="412035" cy="337065"/>
              </a:xfrm>
              <a:prstGeom prst="roundRect">
                <a:avLst/>
              </a:prstGeom>
              <a:solidFill>
                <a:schemeClr val="accent3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2</a:t>
                </a:r>
              </a:p>
            </p:txBody>
          </p:sp>
          <p:sp>
            <p:nvSpPr>
              <p:cNvPr id="36" name="Rounded Rectangle 22">
                <a:extLst>
                  <a:ext uri="{FF2B5EF4-FFF2-40B4-BE49-F238E27FC236}">
                    <a16:creationId xmlns:a16="http://schemas.microsoft.com/office/drawing/2014/main" id="{31EE078C-7B9A-4638-85DD-D284C8A742D9}"/>
                  </a:ext>
                </a:extLst>
              </p:cNvPr>
              <p:cNvSpPr/>
              <p:nvPr/>
            </p:nvSpPr>
            <p:spPr>
              <a:xfrm>
                <a:off x="1790006" y="2891646"/>
                <a:ext cx="412035" cy="337065"/>
              </a:xfrm>
              <a:prstGeom prst="roundRect">
                <a:avLst/>
              </a:prstGeom>
              <a:solidFill>
                <a:srgbClr val="FFC000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3</a:t>
                </a:r>
              </a:p>
            </p:txBody>
          </p:sp>
          <p:sp>
            <p:nvSpPr>
              <p:cNvPr id="37" name="Rounded Rectangle 36">
                <a:extLst>
                  <a:ext uri="{FF2B5EF4-FFF2-40B4-BE49-F238E27FC236}">
                    <a16:creationId xmlns:a16="http://schemas.microsoft.com/office/drawing/2014/main" id="{880FDDAC-248A-4925-9D63-8F37D205D461}"/>
                  </a:ext>
                </a:extLst>
              </p:cNvPr>
              <p:cNvSpPr/>
              <p:nvPr/>
            </p:nvSpPr>
            <p:spPr>
              <a:xfrm>
                <a:off x="2344758" y="2944268"/>
                <a:ext cx="412035" cy="337065"/>
              </a:xfrm>
              <a:prstGeom prst="roundRect">
                <a:avLst/>
              </a:prstGeom>
              <a:solidFill>
                <a:srgbClr val="00B0F0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4</a:t>
                </a:r>
              </a:p>
            </p:txBody>
          </p:sp>
          <p:sp>
            <p:nvSpPr>
              <p:cNvPr id="38" name="Rounded Rectangle 22">
                <a:extLst>
                  <a:ext uri="{FF2B5EF4-FFF2-40B4-BE49-F238E27FC236}">
                    <a16:creationId xmlns:a16="http://schemas.microsoft.com/office/drawing/2014/main" id="{7166CF13-F723-4CC9-801E-9735A85B8A3E}"/>
                  </a:ext>
                </a:extLst>
              </p:cNvPr>
              <p:cNvSpPr/>
              <p:nvPr/>
            </p:nvSpPr>
            <p:spPr>
              <a:xfrm>
                <a:off x="2684558" y="2637970"/>
                <a:ext cx="412035" cy="337065"/>
              </a:xfrm>
              <a:prstGeom prst="roundRect">
                <a:avLst/>
              </a:prstGeom>
              <a:solidFill>
                <a:schemeClr val="accent6">
                  <a:lumMod val="75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5</a:t>
                </a:r>
              </a:p>
            </p:txBody>
          </p:sp>
          <p:sp>
            <p:nvSpPr>
              <p:cNvPr id="40" name="Rounded Rectangle 39"/>
              <p:cNvSpPr/>
              <p:nvPr/>
            </p:nvSpPr>
            <p:spPr>
              <a:xfrm>
                <a:off x="1449659" y="743665"/>
                <a:ext cx="1851102" cy="2991994"/>
              </a:xfrm>
              <a:prstGeom prst="round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64C2BD6-2EC3-4EB7-80D8-9BBD9F4DD80B}"/>
                </a:ext>
              </a:extLst>
            </p:cNvPr>
            <p:cNvSpPr txBox="1"/>
            <p:nvPr/>
          </p:nvSpPr>
          <p:spPr>
            <a:xfrm>
              <a:off x="1567018" y="2147807"/>
              <a:ext cx="928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3520B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2625831" y="2338703"/>
            <a:ext cx="1851102" cy="2953486"/>
            <a:chOff x="5898995" y="2127753"/>
            <a:chExt cx="1851102" cy="2953486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EAFDB0D-1318-4297-86F0-3C4B255171DC}"/>
                </a:ext>
              </a:extLst>
            </p:cNvPr>
            <p:cNvSpPr txBox="1"/>
            <p:nvPr/>
          </p:nvSpPr>
          <p:spPr>
            <a:xfrm>
              <a:off x="6419273" y="2127753"/>
              <a:ext cx="9754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87355A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X-11</a:t>
              </a:r>
            </a:p>
          </p:txBody>
        </p:sp>
        <p:grpSp>
          <p:nvGrpSpPr>
            <p:cNvPr id="44" name="Group 43"/>
            <p:cNvGrpSpPr/>
            <p:nvPr/>
          </p:nvGrpSpPr>
          <p:grpSpPr>
            <a:xfrm>
              <a:off x="6078344" y="3382829"/>
              <a:ext cx="1476710" cy="1310226"/>
              <a:chOff x="5621144" y="2044683"/>
              <a:chExt cx="1476710" cy="1310226"/>
            </a:xfrm>
          </p:grpSpPr>
          <p:sp>
            <p:nvSpPr>
              <p:cNvPr id="53" name="Oval 52"/>
              <p:cNvSpPr/>
              <p:nvPr/>
            </p:nvSpPr>
            <p:spPr>
              <a:xfrm>
                <a:off x="6333287" y="2447544"/>
                <a:ext cx="412394" cy="109728"/>
              </a:xfrm>
              <a:prstGeom prst="ellipse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46" name="Pie 37">
                <a:extLst>
                  <a:ext uri="{FF2B5EF4-FFF2-40B4-BE49-F238E27FC236}">
                    <a16:creationId xmlns:a16="http://schemas.microsoft.com/office/drawing/2014/main" id="{F031ED81-6F99-47D3-A6FB-A202F7D12C5C}"/>
                  </a:ext>
                </a:extLst>
              </p:cNvPr>
              <p:cNvSpPr/>
              <p:nvPr/>
            </p:nvSpPr>
            <p:spPr>
              <a:xfrm>
                <a:off x="5964279" y="2357443"/>
                <a:ext cx="741244" cy="655302"/>
              </a:xfrm>
              <a:prstGeom prst="pie">
                <a:avLst/>
              </a:prstGeom>
              <a:solidFill>
                <a:schemeClr val="accent2">
                  <a:lumMod val="40000"/>
                  <a:lumOff val="60000"/>
                  <a:alpha val="33000"/>
                </a:scheme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ounded Rectangle 22">
                <a:extLst>
                  <a:ext uri="{FF2B5EF4-FFF2-40B4-BE49-F238E27FC236}">
                    <a16:creationId xmlns:a16="http://schemas.microsoft.com/office/drawing/2014/main" id="{30B06C86-41E9-4FD2-9731-35B0B7109450}"/>
                  </a:ext>
                </a:extLst>
              </p:cNvPr>
              <p:cNvSpPr/>
              <p:nvPr/>
            </p:nvSpPr>
            <p:spPr>
              <a:xfrm>
                <a:off x="5621144" y="2479993"/>
                <a:ext cx="412035" cy="337065"/>
              </a:xfrm>
              <a:prstGeom prst="roundRect">
                <a:avLst/>
              </a:prstGeom>
              <a:pattFill prst="pct50">
                <a:fgClr>
                  <a:schemeClr val="accent3"/>
                </a:fgClr>
                <a:bgClr>
                  <a:schemeClr val="bg1"/>
                </a:bgClr>
              </a:pattFill>
              <a:ln>
                <a:prstDash val="sysDot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2</a:t>
                </a:r>
              </a:p>
            </p:txBody>
          </p:sp>
          <p:sp>
            <p:nvSpPr>
              <p:cNvPr id="48" name="Rounded Rectangle 47">
                <a:extLst>
                  <a:ext uri="{FF2B5EF4-FFF2-40B4-BE49-F238E27FC236}">
                    <a16:creationId xmlns:a16="http://schemas.microsoft.com/office/drawing/2014/main" id="{ADA8E43E-CEE6-4E76-840C-8AA5DCDF718F}"/>
                  </a:ext>
                </a:extLst>
              </p:cNvPr>
              <p:cNvSpPr/>
              <p:nvPr/>
            </p:nvSpPr>
            <p:spPr>
              <a:xfrm>
                <a:off x="5794439" y="2965222"/>
                <a:ext cx="412035" cy="337065"/>
              </a:xfrm>
              <a:prstGeom prst="roundRect">
                <a:avLst/>
              </a:prstGeom>
              <a:solidFill>
                <a:srgbClr val="FFC000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3</a:t>
                </a:r>
              </a:p>
            </p:txBody>
          </p:sp>
          <p:sp>
            <p:nvSpPr>
              <p:cNvPr id="49" name="Rounded Rectangle 22">
                <a:extLst>
                  <a:ext uri="{FF2B5EF4-FFF2-40B4-BE49-F238E27FC236}">
                    <a16:creationId xmlns:a16="http://schemas.microsoft.com/office/drawing/2014/main" id="{2946437D-4FDD-4B58-825A-A152C52A43F5}"/>
                  </a:ext>
                </a:extLst>
              </p:cNvPr>
              <p:cNvSpPr/>
              <p:nvPr/>
            </p:nvSpPr>
            <p:spPr>
              <a:xfrm>
                <a:off x="6349191" y="3017844"/>
                <a:ext cx="412035" cy="337065"/>
              </a:xfrm>
              <a:prstGeom prst="roundRect">
                <a:avLst/>
              </a:prstGeom>
              <a:solidFill>
                <a:srgbClr val="00B0F0">
                  <a:alpha val="30000"/>
                </a:srgbClr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4</a:t>
                </a:r>
              </a:p>
            </p:txBody>
          </p:sp>
          <p:sp>
            <p:nvSpPr>
              <p:cNvPr id="50" name="Rounded Rectangle 22">
                <a:extLst>
                  <a:ext uri="{FF2B5EF4-FFF2-40B4-BE49-F238E27FC236}">
                    <a16:creationId xmlns:a16="http://schemas.microsoft.com/office/drawing/2014/main" id="{6A20C383-F39B-4981-A4F9-D4EF8A6C9D4E}"/>
                  </a:ext>
                </a:extLst>
              </p:cNvPr>
              <p:cNvSpPr/>
              <p:nvPr/>
            </p:nvSpPr>
            <p:spPr>
              <a:xfrm>
                <a:off x="6685819" y="2708091"/>
                <a:ext cx="412035" cy="337065"/>
              </a:xfrm>
              <a:prstGeom prst="roundRect">
                <a:avLst/>
              </a:prstGeom>
              <a:pattFill prst="pct50">
                <a:fgClr>
                  <a:schemeClr val="accent6">
                    <a:lumMod val="75000"/>
                  </a:schemeClr>
                </a:fgClr>
                <a:bgClr>
                  <a:schemeClr val="bg1"/>
                </a:bgClr>
              </a:pattFill>
              <a:ln>
                <a:prstDash val="sysDot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5</a:t>
                </a:r>
              </a:p>
            </p:txBody>
          </p:sp>
          <p:sp>
            <p:nvSpPr>
              <p:cNvPr id="54" name="Rounded Rectangle 22">
                <a:extLst>
                  <a:ext uri="{FF2B5EF4-FFF2-40B4-BE49-F238E27FC236}">
                    <a16:creationId xmlns:a16="http://schemas.microsoft.com/office/drawing/2014/main" id="{F11AAA42-44D6-4856-A994-2C4A29A83AEE}"/>
                  </a:ext>
                </a:extLst>
              </p:cNvPr>
              <p:cNvSpPr/>
              <p:nvPr/>
            </p:nvSpPr>
            <p:spPr>
              <a:xfrm>
                <a:off x="5964278" y="2044683"/>
                <a:ext cx="412035" cy="337065"/>
              </a:xfrm>
              <a:prstGeom prst="roundRect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1</a:t>
                </a:r>
              </a:p>
            </p:txBody>
          </p:sp>
        </p:grpSp>
        <p:sp>
          <p:nvSpPr>
            <p:cNvPr id="45" name="Rounded Rectangle 44"/>
            <p:cNvSpPr/>
            <p:nvPr/>
          </p:nvSpPr>
          <p:spPr>
            <a:xfrm>
              <a:off x="5898995" y="2158415"/>
              <a:ext cx="1851102" cy="2922824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" name="Pie 37">
            <a:extLst>
              <a:ext uri="{FF2B5EF4-FFF2-40B4-BE49-F238E27FC236}">
                <a16:creationId xmlns:a16="http://schemas.microsoft.com/office/drawing/2014/main" id="{DF7D2981-1200-4C35-8534-028E567293E0}"/>
              </a:ext>
            </a:extLst>
          </p:cNvPr>
          <p:cNvSpPr/>
          <p:nvPr/>
        </p:nvSpPr>
        <p:spPr>
          <a:xfrm>
            <a:off x="5731280" y="2678410"/>
            <a:ext cx="805664" cy="369617"/>
          </a:xfrm>
          <a:prstGeom prst="pie">
            <a:avLst>
              <a:gd name="adj1" fmla="val 0"/>
              <a:gd name="adj2" fmla="val 16282194"/>
            </a:avLst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2F</a:t>
            </a:r>
          </a:p>
        </p:txBody>
      </p:sp>
      <p:sp>
        <p:nvSpPr>
          <p:cNvPr id="58" name="Multiply 50">
            <a:extLst>
              <a:ext uri="{FF2B5EF4-FFF2-40B4-BE49-F238E27FC236}">
                <a16:creationId xmlns:a16="http://schemas.microsoft.com/office/drawing/2014/main" id="{48E3E2CC-8818-42CE-BF65-7399FBF3CB96}"/>
              </a:ext>
            </a:extLst>
          </p:cNvPr>
          <p:cNvSpPr/>
          <p:nvPr/>
        </p:nvSpPr>
        <p:spPr>
          <a:xfrm>
            <a:off x="3354831" y="3783153"/>
            <a:ext cx="425657" cy="369333"/>
          </a:xfrm>
          <a:prstGeom prst="mathMultiply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Down Arrow 58"/>
          <p:cNvSpPr/>
          <p:nvPr/>
        </p:nvSpPr>
        <p:spPr>
          <a:xfrm rot="1352218">
            <a:off x="5835188" y="3365189"/>
            <a:ext cx="160747" cy="340994"/>
          </a:xfrm>
          <a:prstGeom prst="downArrow">
            <a:avLst/>
          </a:prstGeom>
          <a:solidFill>
            <a:schemeClr val="accent3">
              <a:lumMod val="75000"/>
            </a:schemeClr>
          </a:solidFill>
          <a:ln>
            <a:solidFill>
              <a:schemeClr val="accent3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Pie 37">
            <a:extLst>
              <a:ext uri="{FF2B5EF4-FFF2-40B4-BE49-F238E27FC236}">
                <a16:creationId xmlns:a16="http://schemas.microsoft.com/office/drawing/2014/main" id="{DF7D2981-1200-4C35-8534-028E567293E0}"/>
              </a:ext>
            </a:extLst>
          </p:cNvPr>
          <p:cNvSpPr/>
          <p:nvPr/>
        </p:nvSpPr>
        <p:spPr>
          <a:xfrm>
            <a:off x="3573914" y="2667966"/>
            <a:ext cx="805664" cy="369617"/>
          </a:xfrm>
          <a:prstGeom prst="pie">
            <a:avLst>
              <a:gd name="adj1" fmla="val 0"/>
              <a:gd name="adj2" fmla="val 16282194"/>
            </a:avLst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2F</a:t>
            </a:r>
          </a:p>
        </p:txBody>
      </p:sp>
      <p:sp>
        <p:nvSpPr>
          <p:cNvPr id="61" name="Pie 37">
            <a:extLst>
              <a:ext uri="{FF2B5EF4-FFF2-40B4-BE49-F238E27FC236}">
                <a16:creationId xmlns:a16="http://schemas.microsoft.com/office/drawing/2014/main" id="{DF7D2981-1200-4C35-8534-028E567293E0}"/>
              </a:ext>
            </a:extLst>
          </p:cNvPr>
          <p:cNvSpPr/>
          <p:nvPr/>
        </p:nvSpPr>
        <p:spPr>
          <a:xfrm>
            <a:off x="7660879" y="2731702"/>
            <a:ext cx="805664" cy="369617"/>
          </a:xfrm>
          <a:prstGeom prst="pie">
            <a:avLst>
              <a:gd name="adj1" fmla="val 0"/>
              <a:gd name="adj2" fmla="val 16282194"/>
            </a:avLst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2F</a:t>
            </a:r>
          </a:p>
        </p:txBody>
      </p:sp>
      <p:sp>
        <p:nvSpPr>
          <p:cNvPr id="62" name="Multiply 50">
            <a:extLst>
              <a:ext uri="{FF2B5EF4-FFF2-40B4-BE49-F238E27FC236}">
                <a16:creationId xmlns:a16="http://schemas.microsoft.com/office/drawing/2014/main" id="{E49AC4ED-2112-4077-A9F9-39ED1EDD6936}"/>
              </a:ext>
            </a:extLst>
          </p:cNvPr>
          <p:cNvSpPr/>
          <p:nvPr/>
        </p:nvSpPr>
        <p:spPr>
          <a:xfrm>
            <a:off x="7468123" y="3801377"/>
            <a:ext cx="425657" cy="369333"/>
          </a:xfrm>
          <a:prstGeom prst="mathMultiply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Down Arrow 64"/>
          <p:cNvSpPr/>
          <p:nvPr/>
        </p:nvSpPr>
        <p:spPr>
          <a:xfrm>
            <a:off x="3413541" y="5380381"/>
            <a:ext cx="160747" cy="340994"/>
          </a:xfrm>
          <a:prstGeom prst="downArrow">
            <a:avLst/>
          </a:prstGeom>
          <a:solidFill>
            <a:schemeClr val="accent3">
              <a:lumMod val="75000"/>
            </a:schemeClr>
          </a:solidFill>
          <a:ln>
            <a:solidFill>
              <a:schemeClr val="accent3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Down Arrow 65"/>
          <p:cNvSpPr/>
          <p:nvPr/>
        </p:nvSpPr>
        <p:spPr>
          <a:xfrm rot="1352218">
            <a:off x="7856260" y="3513275"/>
            <a:ext cx="160747" cy="340994"/>
          </a:xfrm>
          <a:prstGeom prst="downArrow">
            <a:avLst/>
          </a:prstGeom>
          <a:solidFill>
            <a:schemeClr val="accent3">
              <a:lumMod val="75000"/>
            </a:schemeClr>
          </a:solidFill>
          <a:ln>
            <a:solidFill>
              <a:schemeClr val="accent3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Multiply 50">
            <a:extLst>
              <a:ext uri="{FF2B5EF4-FFF2-40B4-BE49-F238E27FC236}">
                <a16:creationId xmlns:a16="http://schemas.microsoft.com/office/drawing/2014/main" id="{48E3E2CC-8818-42CE-BF65-7399FBF3CB96}"/>
              </a:ext>
            </a:extLst>
          </p:cNvPr>
          <p:cNvSpPr/>
          <p:nvPr/>
        </p:nvSpPr>
        <p:spPr>
          <a:xfrm>
            <a:off x="7893780" y="3171024"/>
            <a:ext cx="425657" cy="369333"/>
          </a:xfrm>
          <a:prstGeom prst="mathMultiply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Multiply 70">
            <a:extLst>
              <a:ext uri="{FF2B5EF4-FFF2-40B4-BE49-F238E27FC236}">
                <a16:creationId xmlns:a16="http://schemas.microsoft.com/office/drawing/2014/main" id="{E49AC4ED-2112-4077-A9F9-39ED1EDD6936}"/>
              </a:ext>
            </a:extLst>
          </p:cNvPr>
          <p:cNvSpPr/>
          <p:nvPr/>
        </p:nvSpPr>
        <p:spPr>
          <a:xfrm>
            <a:off x="5802002" y="3037583"/>
            <a:ext cx="425657" cy="369333"/>
          </a:xfrm>
          <a:prstGeom prst="mathMultiply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EAFDB0D-1318-4297-86F0-3C4B255171DC}"/>
              </a:ext>
            </a:extLst>
          </p:cNvPr>
          <p:cNvSpPr txBox="1"/>
          <p:nvPr/>
        </p:nvSpPr>
        <p:spPr>
          <a:xfrm>
            <a:off x="2625831" y="5739454"/>
            <a:ext cx="17219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cked ER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gnaling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rtial rescue by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nctional E2F </a:t>
            </a:r>
          </a:p>
        </p:txBody>
      </p:sp>
      <p:sp>
        <p:nvSpPr>
          <p:cNvPr id="73" name="Down Arrow 72"/>
          <p:cNvSpPr/>
          <p:nvPr/>
        </p:nvSpPr>
        <p:spPr>
          <a:xfrm>
            <a:off x="1335645" y="5380381"/>
            <a:ext cx="160747" cy="340994"/>
          </a:xfrm>
          <a:prstGeom prst="downArrow">
            <a:avLst/>
          </a:prstGeom>
          <a:solidFill>
            <a:schemeClr val="accent3">
              <a:lumMod val="75000"/>
            </a:schemeClr>
          </a:solidFill>
          <a:ln>
            <a:solidFill>
              <a:schemeClr val="accent3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EAFDB0D-1318-4297-86F0-3C4B255171DC}"/>
              </a:ext>
            </a:extLst>
          </p:cNvPr>
          <p:cNvSpPr txBox="1"/>
          <p:nvPr/>
        </p:nvSpPr>
        <p:spPr>
          <a:xfrm>
            <a:off x="479709" y="5785621"/>
            <a:ext cx="1917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nctional ER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gnaling</a:t>
            </a:r>
          </a:p>
        </p:txBody>
      </p:sp>
      <p:sp>
        <p:nvSpPr>
          <p:cNvPr id="75" name="Down Arrow 74"/>
          <p:cNvSpPr/>
          <p:nvPr/>
        </p:nvSpPr>
        <p:spPr>
          <a:xfrm>
            <a:off x="7549382" y="5380381"/>
            <a:ext cx="160747" cy="340994"/>
          </a:xfrm>
          <a:prstGeom prst="downArrow">
            <a:avLst/>
          </a:prstGeom>
          <a:solidFill>
            <a:schemeClr val="accent3">
              <a:lumMod val="75000"/>
            </a:schemeClr>
          </a:solidFill>
          <a:ln>
            <a:solidFill>
              <a:schemeClr val="accent3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EAFDB0D-1318-4297-86F0-3C4B255171DC}"/>
              </a:ext>
            </a:extLst>
          </p:cNvPr>
          <p:cNvSpPr txBox="1"/>
          <p:nvPr/>
        </p:nvSpPr>
        <p:spPr>
          <a:xfrm>
            <a:off x="6738955" y="5785621"/>
            <a:ext cx="205857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cked ER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gnaling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cked E2F signaling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ynergistic down regulation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ER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E2F axis proteins</a:t>
            </a:r>
          </a:p>
        </p:txBody>
      </p:sp>
      <p:sp>
        <p:nvSpPr>
          <p:cNvPr id="77" name="Down Arrow 76"/>
          <p:cNvSpPr/>
          <p:nvPr/>
        </p:nvSpPr>
        <p:spPr>
          <a:xfrm>
            <a:off x="5438534" y="5380381"/>
            <a:ext cx="160747" cy="340994"/>
          </a:xfrm>
          <a:prstGeom prst="downArrow">
            <a:avLst/>
          </a:prstGeom>
          <a:solidFill>
            <a:schemeClr val="accent3">
              <a:lumMod val="75000"/>
            </a:schemeClr>
          </a:solidFill>
          <a:ln>
            <a:solidFill>
              <a:schemeClr val="accent3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EAFDB0D-1318-4297-86F0-3C4B255171DC}"/>
              </a:ext>
            </a:extLst>
          </p:cNvPr>
          <p:cNvSpPr txBox="1"/>
          <p:nvPr/>
        </p:nvSpPr>
        <p:spPr>
          <a:xfrm>
            <a:off x="4545788" y="5785621"/>
            <a:ext cx="220925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cked E2F signaling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rtial rescue of ER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gnaling by enhanced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oregulato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eractions</a:t>
            </a:r>
          </a:p>
        </p:txBody>
      </p:sp>
      <p:sp>
        <p:nvSpPr>
          <p:cNvPr id="64" name="Down Arrow 63"/>
          <p:cNvSpPr/>
          <p:nvPr/>
        </p:nvSpPr>
        <p:spPr>
          <a:xfrm rot="1352218">
            <a:off x="3986247" y="3185777"/>
            <a:ext cx="160747" cy="436096"/>
          </a:xfrm>
          <a:prstGeom prst="downArrow">
            <a:avLst/>
          </a:prstGeom>
          <a:solidFill>
            <a:schemeClr val="accent3">
              <a:lumMod val="75000"/>
            </a:schemeClr>
          </a:solidFill>
          <a:ln>
            <a:solidFill>
              <a:schemeClr val="accent3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4A927A3-5D12-4FF0-95F0-D7B74DC79468}"/>
              </a:ext>
            </a:extLst>
          </p:cNvPr>
          <p:cNvSpPr txBox="1"/>
          <p:nvPr/>
        </p:nvSpPr>
        <p:spPr>
          <a:xfrm>
            <a:off x="7733102" y="65969"/>
            <a:ext cx="8755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ure S10</a:t>
            </a:r>
          </a:p>
        </p:txBody>
      </p:sp>
      <p:sp>
        <p:nvSpPr>
          <p:cNvPr id="70" name="Rectangle 69"/>
          <p:cNvSpPr/>
          <p:nvPr/>
        </p:nvSpPr>
        <p:spPr>
          <a:xfrm>
            <a:off x="443780" y="689858"/>
            <a:ext cx="827295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0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ematic model for mechanisms of ERX-11 and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lbociclib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mbination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rapy. ERX-11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ocks ER signaling, however E2F signaling by cancer cells contributes to partial rescue of ER signaling by enhancing ER-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egulator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teractions via phosphorylation of ER and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egulators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tc.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lbociclib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locks E2F signaling, however, cancer cells overcome that inhibition by enhancing ER-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egulator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teractions. ERX-11+palbociclib therapy blocks both ER and E2F signaling and dual blockage synergistically down regulate levels of key proteins in E2F and ER signaling pathways. </a:t>
            </a:r>
            <a:endParaRPr lang="en-US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0116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530936E-F09D-4A69-AD29-BB15FE20B1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6785251"/>
              </p:ext>
            </p:extLst>
          </p:nvPr>
        </p:nvGraphicFramePr>
        <p:xfrm>
          <a:off x="405575" y="879872"/>
          <a:ext cx="2695575" cy="26134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1" name="Prism 8" r:id="rId3" imgW="3594875" imgH="3485211" progId="Prism8.Document">
                  <p:embed/>
                </p:oleObj>
              </mc:Choice>
              <mc:Fallback>
                <p:oleObj name="Prism 8" r:id="rId3" imgW="3594875" imgH="3485211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530936E-F09D-4A69-AD29-BB15FE20B1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5575" y="879872"/>
                        <a:ext cx="2695575" cy="26134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F1D49C6-D931-461E-8138-BE311A8005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6148017"/>
              </p:ext>
            </p:extLst>
          </p:nvPr>
        </p:nvGraphicFramePr>
        <p:xfrm>
          <a:off x="2874455" y="879872"/>
          <a:ext cx="2695575" cy="26134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2" name="Prism 8" r:id="rId5" imgW="3594875" imgH="3485211" progId="Prism8.Document">
                  <p:embed/>
                </p:oleObj>
              </mc:Choice>
              <mc:Fallback>
                <p:oleObj name="Prism 8" r:id="rId5" imgW="3594875" imgH="3485211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F1D49C6-D931-461E-8138-BE311A8005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74455" y="879872"/>
                        <a:ext cx="2695575" cy="26134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D93C92B-32B8-4C34-8700-E85C2AB6F2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7328897"/>
              </p:ext>
            </p:extLst>
          </p:nvPr>
        </p:nvGraphicFramePr>
        <p:xfrm>
          <a:off x="5363575" y="879872"/>
          <a:ext cx="2675335" cy="26205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3" name="Prism 8" r:id="rId7" imgW="3567504" imgH="3494575" progId="Prism8.Document">
                  <p:embed/>
                </p:oleObj>
              </mc:Choice>
              <mc:Fallback>
                <p:oleObj name="Prism 8" r:id="rId7" imgW="3567504" imgH="3494575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D93C92B-32B8-4C34-8700-E85C2AB6F2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363575" y="879872"/>
                        <a:ext cx="2675335" cy="26205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FD1934B-5A36-4996-8FAD-37193B8B513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16744" y="3493294"/>
          <a:ext cx="2699147" cy="26134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4" name="Prism 8" r:id="rId9" imgW="3599556" imgH="3485211" progId="Prism8.Document">
                  <p:embed/>
                </p:oleObj>
              </mc:Choice>
              <mc:Fallback>
                <p:oleObj name="Prism 8" r:id="rId9" imgW="3599556" imgH="3485211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AFD1934B-5A36-4996-8FAD-37193B8B51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16744" y="3493294"/>
                        <a:ext cx="2699147" cy="26134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4B3D212-B8A9-4CD2-8EC1-674FBEC358B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39478" y="3493294"/>
          <a:ext cx="2675335" cy="26134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5" name="Prism 8" r:id="rId11" imgW="3567504" imgH="3485211" progId="Prism8.Document">
                  <p:embed/>
                </p:oleObj>
              </mc:Choice>
              <mc:Fallback>
                <p:oleObj name="Prism 8" r:id="rId11" imgW="3567504" imgH="3485211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4B3D212-B8A9-4CD2-8EC1-674FBEC358B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439478" y="3493294"/>
                        <a:ext cx="2675335" cy="26134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3ACFE9F-4E31-428A-A3E3-AB8A22BCE2AD}"/>
              </a:ext>
            </a:extLst>
          </p:cNvPr>
          <p:cNvSpPr txBox="1"/>
          <p:nvPr/>
        </p:nvSpPr>
        <p:spPr>
          <a:xfrm>
            <a:off x="616744" y="260805"/>
            <a:ext cx="8274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8" name="Rectangle 7"/>
          <p:cNvSpPr/>
          <p:nvPr/>
        </p:nvSpPr>
        <p:spPr>
          <a:xfrm>
            <a:off x="2244500" y="6294506"/>
            <a:ext cx="263726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*, p&lt;0.01, ***, p&lt;0.001, ****,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&lt;0.0001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57634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96B815F3-A8F3-4A29-BBD6-D7F7C3FFCBB2}"/>
              </a:ext>
            </a:extLst>
          </p:cNvPr>
          <p:cNvSpPr txBox="1"/>
          <p:nvPr/>
        </p:nvSpPr>
        <p:spPr>
          <a:xfrm>
            <a:off x="179626" y="6800"/>
            <a:ext cx="8274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589D4852-296D-4AC0-88A1-DC0E6ACDB4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1076" y="427564"/>
            <a:ext cx="8920461" cy="3464925"/>
          </a:xfrm>
          <a:prstGeom prst="rect">
            <a:avLst/>
          </a:prstGeom>
        </p:spPr>
      </p:pic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686E41C-6BF8-4863-9320-744572C507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4308116"/>
              </p:ext>
            </p:extLst>
          </p:nvPr>
        </p:nvGraphicFramePr>
        <p:xfrm>
          <a:off x="6005591" y="3887807"/>
          <a:ext cx="3374703" cy="30643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6" name="Prism 8" r:id="rId4" imgW="3729205" imgH="3386168" progId="Prism8.Document">
                  <p:embed/>
                </p:oleObj>
              </mc:Choice>
              <mc:Fallback>
                <p:oleObj name="Prism 8" r:id="rId4" imgW="3729205" imgH="3386168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686E41C-6BF8-4863-9320-744572C507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05591" y="3887807"/>
                        <a:ext cx="3374703" cy="30643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217F62DE-0C3B-4F5D-A776-E6BC0B7984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9882500"/>
              </p:ext>
            </p:extLst>
          </p:nvPr>
        </p:nvGraphicFramePr>
        <p:xfrm>
          <a:off x="2972258" y="3967934"/>
          <a:ext cx="3357640" cy="2908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7" name="Prism 8" r:id="rId6" imgW="3729205" imgH="3230582" progId="Prism8.Document">
                  <p:embed/>
                </p:oleObj>
              </mc:Choice>
              <mc:Fallback>
                <p:oleObj name="Prism 8" r:id="rId6" imgW="3729205" imgH="3230582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217F62DE-0C3B-4F5D-A776-E6BC0B7984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972258" y="3967934"/>
                        <a:ext cx="3357640" cy="2908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1BFECC90-6159-4078-88FE-0CE82DB4C4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3481644"/>
              </p:ext>
            </p:extLst>
          </p:nvPr>
        </p:nvGraphicFramePr>
        <p:xfrm>
          <a:off x="-218815" y="4005657"/>
          <a:ext cx="3357640" cy="2908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8" name="Prism 8" r:id="rId8" imgW="3729205" imgH="3230582" progId="Prism8.Document">
                  <p:embed/>
                </p:oleObj>
              </mc:Choice>
              <mc:Fallback>
                <p:oleObj name="Prism 8" r:id="rId8" imgW="3729205" imgH="3230582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1BFECC90-6159-4078-88FE-0CE82DB4C4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-218815" y="4005657"/>
                        <a:ext cx="3357640" cy="2908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/>
          <p:cNvSpPr/>
          <p:nvPr/>
        </p:nvSpPr>
        <p:spPr>
          <a:xfrm>
            <a:off x="2564789" y="6628044"/>
            <a:ext cx="114807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***,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&lt;0.0001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0618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9399" y="403853"/>
            <a:ext cx="8274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157A770-4F79-4609-B9E4-F728ED893DB5}"/>
              </a:ext>
            </a:extLst>
          </p:cNvPr>
          <p:cNvSpPr txBox="1"/>
          <p:nvPr/>
        </p:nvSpPr>
        <p:spPr>
          <a:xfrm>
            <a:off x="411226" y="343962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BB3A924-38C1-47B5-9D6F-5B8CA57CAB87}"/>
              </a:ext>
            </a:extLst>
          </p:cNvPr>
          <p:cNvSpPr txBox="1"/>
          <p:nvPr/>
        </p:nvSpPr>
        <p:spPr>
          <a:xfrm>
            <a:off x="3236488" y="33840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2" name="TextBox 9">
            <a:extLst>
              <a:ext uri="{FF2B5EF4-FFF2-40B4-BE49-F238E27FC236}">
                <a16:creationId xmlns:a16="http://schemas.microsoft.com/office/drawing/2014/main" id="{D33030FB-A825-460E-96F0-BBD6858D2C4E}"/>
              </a:ext>
            </a:extLst>
          </p:cNvPr>
          <p:cNvSpPr txBox="1"/>
          <p:nvPr/>
        </p:nvSpPr>
        <p:spPr>
          <a:xfrm>
            <a:off x="3197692" y="2782708"/>
            <a:ext cx="1563249" cy="230832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RX-11 -                           -</a:t>
            </a:r>
          </a:p>
        </p:txBody>
      </p:sp>
      <p:sp>
        <p:nvSpPr>
          <p:cNvPr id="63" name="Right Triangle 62">
            <a:extLst>
              <a:ext uri="{FF2B5EF4-FFF2-40B4-BE49-F238E27FC236}">
                <a16:creationId xmlns:a16="http://schemas.microsoft.com/office/drawing/2014/main" id="{9B5CD888-1863-4C8C-8D46-93E5A9B96463}"/>
              </a:ext>
            </a:extLst>
          </p:cNvPr>
          <p:cNvSpPr>
            <a:spLocks noChangeAspect="1"/>
          </p:cNvSpPr>
          <p:nvPr/>
        </p:nvSpPr>
        <p:spPr>
          <a:xfrm flipH="1">
            <a:off x="3931596" y="2862985"/>
            <a:ext cx="520864" cy="49420"/>
          </a:xfrm>
          <a:prstGeom prst="rtTriangle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4" name="Right Triangle 63">
            <a:extLst>
              <a:ext uri="{FF2B5EF4-FFF2-40B4-BE49-F238E27FC236}">
                <a16:creationId xmlns:a16="http://schemas.microsoft.com/office/drawing/2014/main" id="{1401861C-4302-4AB1-9176-2D8FEA066776}"/>
              </a:ext>
            </a:extLst>
          </p:cNvPr>
          <p:cNvSpPr>
            <a:spLocks noChangeAspect="1"/>
          </p:cNvSpPr>
          <p:nvPr/>
        </p:nvSpPr>
        <p:spPr>
          <a:xfrm flipH="1">
            <a:off x="4808408" y="2862985"/>
            <a:ext cx="520864" cy="45760"/>
          </a:xfrm>
          <a:prstGeom prst="rtTriangle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5" name="TextBox 12">
            <a:extLst>
              <a:ext uri="{FF2B5EF4-FFF2-40B4-BE49-F238E27FC236}">
                <a16:creationId xmlns:a16="http://schemas.microsoft.com/office/drawing/2014/main" id="{7FD5952D-DECC-42C1-9E60-ECC23BC62D98}"/>
              </a:ext>
            </a:extLst>
          </p:cNvPr>
          <p:cNvSpPr txBox="1"/>
          <p:nvPr/>
        </p:nvSpPr>
        <p:spPr>
          <a:xfrm>
            <a:off x="3263932" y="3005743"/>
            <a:ext cx="2223686" cy="230832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ibo</a:t>
            </a:r>
            <a:r>
              <a: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   -      -      -      -     +     +     +     +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FFD43ADA-996A-4AD3-A58C-78C2CA9DDD35}"/>
              </a:ext>
            </a:extLst>
          </p:cNvPr>
          <p:cNvGrpSpPr/>
          <p:nvPr/>
        </p:nvGrpSpPr>
        <p:grpSpPr>
          <a:xfrm>
            <a:off x="954366" y="796823"/>
            <a:ext cx="2282122" cy="2461715"/>
            <a:chOff x="2249239" y="2226819"/>
            <a:chExt cx="4006364" cy="4321654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98DF1986-A2CC-4D3D-8A91-2D49E558BE7E}"/>
                </a:ext>
              </a:extLst>
            </p:cNvPr>
            <p:cNvGrpSpPr/>
            <p:nvPr/>
          </p:nvGrpSpPr>
          <p:grpSpPr>
            <a:xfrm>
              <a:off x="2249239" y="5710962"/>
              <a:ext cx="4006364" cy="837511"/>
              <a:chOff x="199959" y="2575437"/>
              <a:chExt cx="4006364" cy="827524"/>
            </a:xfrm>
          </p:grpSpPr>
          <p:sp>
            <p:nvSpPr>
              <p:cNvPr id="42" name="TextBox 9">
                <a:extLst>
                  <a:ext uri="{FF2B5EF4-FFF2-40B4-BE49-F238E27FC236}">
                    <a16:creationId xmlns:a16="http://schemas.microsoft.com/office/drawing/2014/main" id="{E52BD171-0294-4714-A99A-40CADDA14C72}"/>
                  </a:ext>
                </a:extLst>
              </p:cNvPr>
              <p:cNvSpPr txBox="1"/>
              <p:nvPr/>
            </p:nvSpPr>
            <p:spPr>
              <a:xfrm>
                <a:off x="199959" y="2575437"/>
                <a:ext cx="2744351" cy="400404"/>
              </a:xfrm>
              <a:prstGeom prst="rect">
                <a:avLst/>
              </a:prstGeom>
              <a:noFill/>
              <a:ln>
                <a:noFill/>
              </a:ln>
              <a:effectLst/>
            </p:spPr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ERX-11 -                           -</a:t>
                </a:r>
              </a:p>
            </p:txBody>
          </p:sp>
          <p:sp>
            <p:nvSpPr>
              <p:cNvPr id="43" name="Right Triangle 42">
                <a:extLst>
                  <a:ext uri="{FF2B5EF4-FFF2-40B4-BE49-F238E27FC236}">
                    <a16:creationId xmlns:a16="http://schemas.microsoft.com/office/drawing/2014/main" id="{FA72F096-D0A1-4F5D-9AF7-D13B4ED70BC6}"/>
                  </a:ext>
                </a:extLst>
              </p:cNvPr>
              <p:cNvSpPr>
                <a:spLocks noChangeAspect="1"/>
              </p:cNvSpPr>
              <p:nvPr/>
            </p:nvSpPr>
            <p:spPr>
              <a:xfrm flipH="1">
                <a:off x="1415269" y="2727408"/>
                <a:ext cx="914399" cy="85725"/>
              </a:xfrm>
              <a:prstGeom prst="rtTriangle">
                <a:avLst/>
              </a:prstGeom>
              <a:solidFill>
                <a:sysClr val="windowText" lastClr="000000"/>
              </a:solidFill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  <p:txBody>
              <a:bodyPr rtlCol="0" anchor="t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44" name="Right Triangle 43">
                <a:extLst>
                  <a:ext uri="{FF2B5EF4-FFF2-40B4-BE49-F238E27FC236}">
                    <a16:creationId xmlns:a16="http://schemas.microsoft.com/office/drawing/2014/main" id="{6D2B9B2F-EF46-41BF-80A3-6854CAE9159B}"/>
                  </a:ext>
                </a:extLst>
              </p:cNvPr>
              <p:cNvSpPr>
                <a:spLocks noChangeAspect="1"/>
              </p:cNvSpPr>
              <p:nvPr/>
            </p:nvSpPr>
            <p:spPr>
              <a:xfrm flipH="1">
                <a:off x="3067639" y="2735077"/>
                <a:ext cx="914399" cy="79376"/>
              </a:xfrm>
              <a:prstGeom prst="rtTriangle">
                <a:avLst/>
              </a:prstGeom>
              <a:solidFill>
                <a:sysClr val="windowText" lastClr="000000"/>
              </a:solidFill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  <p:txBody>
              <a:bodyPr rtlCol="0" anchor="t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45" name="TextBox 12">
                <a:extLst>
                  <a:ext uri="{FF2B5EF4-FFF2-40B4-BE49-F238E27FC236}">
                    <a16:creationId xmlns:a16="http://schemas.microsoft.com/office/drawing/2014/main" id="{87B51C2A-37A1-4D5C-9768-43CCF75F372B}"/>
                  </a:ext>
                </a:extLst>
              </p:cNvPr>
              <p:cNvSpPr txBox="1"/>
              <p:nvPr/>
            </p:nvSpPr>
            <p:spPr>
              <a:xfrm>
                <a:off x="302546" y="3002557"/>
                <a:ext cx="3903777" cy="400404"/>
              </a:xfrm>
              <a:prstGeom prst="rect">
                <a:avLst/>
              </a:prstGeom>
              <a:noFill/>
              <a:ln>
                <a:noFill/>
              </a:ln>
              <a:effectLst/>
            </p:spPr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Ribo</a:t>
                </a:r>
                <a:r>
                  <a:rPr kumimoji="0" lang="en-US" sz="9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   -      -      -      -     +     +     +     +</a:t>
                </a:r>
              </a:p>
            </p:txBody>
          </p:sp>
        </p:grp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8BB2F851-ACAB-4E3A-A36D-0D9B0523259C}"/>
                </a:ext>
              </a:extLst>
            </p:cNvPr>
            <p:cNvSpPr/>
            <p:nvPr/>
          </p:nvSpPr>
          <p:spPr>
            <a:xfrm>
              <a:off x="3515635" y="2226819"/>
              <a:ext cx="18473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F759B3A7-EBF9-4D9A-BBB9-59807EEA6578}"/>
              </a:ext>
            </a:extLst>
          </p:cNvPr>
          <p:cNvSpPr txBox="1"/>
          <p:nvPr/>
        </p:nvSpPr>
        <p:spPr>
          <a:xfrm>
            <a:off x="426528" y="104054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Rectangle 4"/>
          <p:cNvSpPr/>
          <p:nvPr/>
        </p:nvSpPr>
        <p:spPr>
          <a:xfrm>
            <a:off x="1462772" y="6053012"/>
            <a:ext cx="246574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</a:rPr>
              <a:t>*,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</a:rPr>
              <a:t>p&lt;0.05, ***, p&lt;0.01, ****,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</a:rPr>
              <a:t>p&lt;0.0001</a:t>
            </a:r>
            <a:endParaRPr lang="en-US" sz="1100" dirty="0"/>
          </a:p>
        </p:txBody>
      </p:sp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2"/>
          <a:srcRect b="22249"/>
          <a:stretch/>
        </p:blipFill>
        <p:spPr>
          <a:xfrm>
            <a:off x="894705" y="1144253"/>
            <a:ext cx="2255520" cy="1658879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3"/>
          <a:srcRect b="13573"/>
          <a:stretch/>
        </p:blipFill>
        <p:spPr>
          <a:xfrm>
            <a:off x="3150225" y="1068777"/>
            <a:ext cx="2255520" cy="1718875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76190" y="3753340"/>
            <a:ext cx="2556136" cy="1555458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5190" y="3808956"/>
            <a:ext cx="2504891" cy="1499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98496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9581" y="1079996"/>
            <a:ext cx="8244840" cy="462534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49581" y="292887"/>
            <a:ext cx="799040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lective list of proteins identified in mass spectrometry analyses that are altered by ERX-11+palbociclib combination therapy compared to monotherapy are shown.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73914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5929557" y="4168993"/>
            <a:ext cx="2017327" cy="2027340"/>
            <a:chOff x="3796192" y="4335420"/>
            <a:chExt cx="2017327" cy="2027340"/>
          </a:xfrm>
        </p:grpSpPr>
        <p:pic>
          <p:nvPicPr>
            <p:cNvPr id="9" name="Picture 8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42"/>
            <a:stretch/>
          </p:blipFill>
          <p:spPr>
            <a:xfrm>
              <a:off x="4533359" y="4834510"/>
              <a:ext cx="1280160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TextBox 9"/>
            <p:cNvSpPr txBox="1"/>
            <p:nvPr/>
          </p:nvSpPr>
          <p:spPr>
            <a:xfrm>
              <a:off x="3796192" y="4847220"/>
              <a:ext cx="7986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-ERK1/2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909159" y="4600350"/>
              <a:ext cx="7103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RX-11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968956" y="4335420"/>
              <a:ext cx="5644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albo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424796" y="4599494"/>
              <a:ext cx="13388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-        +       -       +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417153" y="4339791"/>
              <a:ext cx="13388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-         -       +      +</a:t>
              </a:r>
            </a:p>
          </p:txBody>
        </p:sp>
        <p:pic>
          <p:nvPicPr>
            <p:cNvPr id="15" name="Picture 14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0" r="4544"/>
            <a:stretch/>
          </p:blipFill>
          <p:spPr>
            <a:xfrm>
              <a:off x="4533359" y="5136343"/>
              <a:ext cx="1280160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" name="TextBox 15"/>
            <p:cNvSpPr txBox="1"/>
            <p:nvPr/>
          </p:nvSpPr>
          <p:spPr>
            <a:xfrm>
              <a:off x="3930431" y="5150936"/>
              <a:ext cx="7536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</a:p>
          </p:txBody>
        </p:sp>
        <p:pic>
          <p:nvPicPr>
            <p:cNvPr id="17" name="Picture 16"/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130" b="19720"/>
            <a:stretch/>
          </p:blipFill>
          <p:spPr>
            <a:xfrm>
              <a:off x="4533359" y="6055023"/>
              <a:ext cx="1280160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8" name="TextBox 17"/>
            <p:cNvSpPr txBox="1"/>
            <p:nvPr/>
          </p:nvSpPr>
          <p:spPr>
            <a:xfrm>
              <a:off x="3910321" y="6101150"/>
              <a:ext cx="70923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19" name="Picture 18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33359" y="5445183"/>
              <a:ext cx="1280160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" name="TextBox 19"/>
            <p:cNvSpPr txBox="1"/>
            <p:nvPr/>
          </p:nvSpPr>
          <p:spPr>
            <a:xfrm>
              <a:off x="3806188" y="5445183"/>
              <a:ext cx="7500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clin D1</a:t>
              </a:r>
            </a:p>
          </p:txBody>
        </p:sp>
        <p:pic>
          <p:nvPicPr>
            <p:cNvPr id="21" name="Picture 20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34" r="2643"/>
            <a:stretch/>
          </p:blipFill>
          <p:spPr>
            <a:xfrm>
              <a:off x="4533359" y="5750039"/>
              <a:ext cx="1280160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2" name="TextBox 21"/>
            <p:cNvSpPr txBox="1"/>
            <p:nvPr/>
          </p:nvSpPr>
          <p:spPr>
            <a:xfrm>
              <a:off x="4126317" y="5756394"/>
              <a:ext cx="45647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CD51E175-5015-7C43-BA32-A192217BD126}"/>
              </a:ext>
            </a:extLst>
          </p:cNvPr>
          <p:cNvSpPr txBox="1"/>
          <p:nvPr/>
        </p:nvSpPr>
        <p:spPr>
          <a:xfrm>
            <a:off x="809072" y="3194778"/>
            <a:ext cx="274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D51E175-5015-7C43-BA32-A192217BD126}"/>
              </a:ext>
            </a:extLst>
          </p:cNvPr>
          <p:cNvSpPr txBox="1"/>
          <p:nvPr/>
        </p:nvSpPr>
        <p:spPr>
          <a:xfrm>
            <a:off x="5596903" y="3194778"/>
            <a:ext cx="274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9573" name="Picture 357" descr="Z:\Surya\Surya Project data\CDK inhibitor project\Cell cycle\Cell Cycle-MCF7 cells-48hrs.jpg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16" t="3952" r="3166" b="4064"/>
          <a:stretch/>
        </p:blipFill>
        <p:spPr bwMode="auto">
          <a:xfrm>
            <a:off x="1083818" y="3564110"/>
            <a:ext cx="1873332" cy="30986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575" name="Picture 359" descr="Z:\Surya\Surya Project data\CDK inhibitor project\Cell cycle\Cell Cycle-MCF7_TamR cells-48hrs.jpg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4" t="2146" r="2946" b="4599"/>
          <a:stretch/>
        </p:blipFill>
        <p:spPr bwMode="auto">
          <a:xfrm>
            <a:off x="3179570" y="3507649"/>
            <a:ext cx="2001795" cy="30644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2D257E17-D8D6-4018-B434-09205615005D}"/>
              </a:ext>
            </a:extLst>
          </p:cNvPr>
          <p:cNvSpPr txBox="1"/>
          <p:nvPr/>
        </p:nvSpPr>
        <p:spPr>
          <a:xfrm>
            <a:off x="2420850" y="2188573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ERX-1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18DB62F-F3E9-490D-BEAB-02E56D845B12}"/>
              </a:ext>
            </a:extLst>
          </p:cNvPr>
          <p:cNvSpPr txBox="1"/>
          <p:nvPr/>
        </p:nvSpPr>
        <p:spPr>
          <a:xfrm>
            <a:off x="2222282" y="2017130"/>
            <a:ext cx="7922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>
                <a:solidFill>
                  <a:schemeClr val="tx1">
                    <a:lumMod val="95000"/>
                    <a:lumOff val="5000"/>
                  </a:schemeClr>
                </a:solidFill>
              </a:rPr>
              <a:t>Palbociclib</a:t>
            </a:r>
            <a:endParaRPr lang="en-US" sz="1100" dirty="0">
              <a:solidFill>
                <a:schemeClr val="tx1">
                  <a:lumMod val="95000"/>
                  <a:lumOff val="5000"/>
                </a:schemeClr>
              </a:solidFill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07660C8-EFF7-4309-9FE0-6E261D09BCAA}"/>
              </a:ext>
            </a:extLst>
          </p:cNvPr>
          <p:cNvSpPr/>
          <p:nvPr/>
        </p:nvSpPr>
        <p:spPr>
          <a:xfrm>
            <a:off x="2540009" y="2441091"/>
            <a:ext cx="47320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3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SRC1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A652291A-4DA9-4FA8-A231-9616E8981DC3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99" t="63618" r="16434" b="31611"/>
          <a:stretch/>
        </p:blipFill>
        <p:spPr>
          <a:xfrm>
            <a:off x="2997167" y="2836013"/>
            <a:ext cx="1380744" cy="233386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9" name="Group 28">
            <a:extLst>
              <a:ext uri="{FF2B5EF4-FFF2-40B4-BE49-F238E27FC236}">
                <a16:creationId xmlns:a16="http://schemas.microsoft.com/office/drawing/2014/main" id="{7980C5E1-83DB-4983-90F4-89BD32EBCB48}"/>
              </a:ext>
            </a:extLst>
          </p:cNvPr>
          <p:cNvGrpSpPr/>
          <p:nvPr/>
        </p:nvGrpSpPr>
        <p:grpSpPr>
          <a:xfrm>
            <a:off x="4456247" y="1817320"/>
            <a:ext cx="1666461" cy="599993"/>
            <a:chOff x="5142008" y="3985701"/>
            <a:chExt cx="1666461" cy="599993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4863652-6067-4236-A694-CE6A301B4584}"/>
                </a:ext>
              </a:extLst>
            </p:cNvPr>
            <p:cNvSpPr txBox="1"/>
            <p:nvPr/>
          </p:nvSpPr>
          <p:spPr>
            <a:xfrm>
              <a:off x="5142008" y="4339473"/>
              <a:ext cx="13388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        +          -        +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ACFC565-394D-43FF-818A-B3DD695B5337}"/>
                </a:ext>
              </a:extLst>
            </p:cNvPr>
            <p:cNvSpPr txBox="1"/>
            <p:nvPr/>
          </p:nvSpPr>
          <p:spPr>
            <a:xfrm>
              <a:off x="5142009" y="4181437"/>
              <a:ext cx="16664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        -          +        +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9B85B48-230B-49DB-9D3D-1910B9A091A8}"/>
                </a:ext>
              </a:extLst>
            </p:cNvPr>
            <p:cNvSpPr txBox="1"/>
            <p:nvPr/>
          </p:nvSpPr>
          <p:spPr>
            <a:xfrm>
              <a:off x="5495079" y="3985701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P: IgG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66089CBB-0EF4-4730-9F97-234E73121F59}"/>
              </a:ext>
            </a:extLst>
          </p:cNvPr>
          <p:cNvGrpSpPr/>
          <p:nvPr/>
        </p:nvGrpSpPr>
        <p:grpSpPr>
          <a:xfrm>
            <a:off x="3033924" y="1808141"/>
            <a:ext cx="1666461" cy="621669"/>
            <a:chOff x="6891558" y="3998827"/>
            <a:chExt cx="1666461" cy="621669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963B426-27A5-4197-8195-7EDAA80B07AE}"/>
                </a:ext>
              </a:extLst>
            </p:cNvPr>
            <p:cNvSpPr txBox="1"/>
            <p:nvPr/>
          </p:nvSpPr>
          <p:spPr>
            <a:xfrm>
              <a:off x="7274824" y="3998827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P: ER</a:t>
              </a:r>
              <a:r>
                <a:rPr lang="el-G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13CCE0D-FA0D-4243-B2DE-C7642FEDEFE8}"/>
                </a:ext>
              </a:extLst>
            </p:cNvPr>
            <p:cNvSpPr txBox="1"/>
            <p:nvPr/>
          </p:nvSpPr>
          <p:spPr>
            <a:xfrm>
              <a:off x="6891558" y="4374275"/>
              <a:ext cx="13388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        +          -        +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FC489BC-675B-4337-BCAB-9437CFE34063}"/>
                </a:ext>
              </a:extLst>
            </p:cNvPr>
            <p:cNvSpPr txBox="1"/>
            <p:nvPr/>
          </p:nvSpPr>
          <p:spPr>
            <a:xfrm>
              <a:off x="6891559" y="4216239"/>
              <a:ext cx="16664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        -          +        +</a:t>
              </a: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7AC56D57-8C22-476C-A7AE-EDE9A1CBE826}"/>
                </a:ext>
              </a:extLst>
            </p:cNvPr>
            <p:cNvCxnSpPr/>
            <p:nvPr/>
          </p:nvCxnSpPr>
          <p:spPr>
            <a:xfrm>
              <a:off x="6909248" y="4222693"/>
              <a:ext cx="122189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8" name="Picture 37">
            <a:extLst>
              <a:ext uri="{FF2B5EF4-FFF2-40B4-BE49-F238E27FC236}">
                <a16:creationId xmlns:a16="http://schemas.microsoft.com/office/drawing/2014/main" id="{BA8F775D-D6DD-4E07-9FB5-6E7A742143C1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32" t="63798" r="58038" b="31439"/>
          <a:stretch/>
        </p:blipFill>
        <p:spPr>
          <a:xfrm>
            <a:off x="4411375" y="2828475"/>
            <a:ext cx="1380744" cy="2368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Rectangle 38">
            <a:extLst>
              <a:ext uri="{FF2B5EF4-FFF2-40B4-BE49-F238E27FC236}">
                <a16:creationId xmlns:a16="http://schemas.microsoft.com/office/drawing/2014/main" id="{C774D97B-D2B2-44CB-AD65-2665EA475F4F}"/>
              </a:ext>
            </a:extLst>
          </p:cNvPr>
          <p:cNvSpPr/>
          <p:nvPr/>
        </p:nvSpPr>
        <p:spPr>
          <a:xfrm>
            <a:off x="2536456" y="2809313"/>
            <a:ext cx="47320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3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SRC3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63C17C10-2BE9-4046-8458-B7809F613C77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876" t="57240" r="12181" b="34121"/>
          <a:stretch/>
        </p:blipFill>
        <p:spPr>
          <a:xfrm>
            <a:off x="2996262" y="2394239"/>
            <a:ext cx="1383526" cy="2703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78754D1-8D7E-40A8-AB24-3FB5FCD18D7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088" t="56921" r="53640" b="36029"/>
          <a:stretch/>
        </p:blipFill>
        <p:spPr>
          <a:xfrm>
            <a:off x="4412426" y="2390263"/>
            <a:ext cx="1380744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6DA900F2-A642-406F-802B-81A712183573}"/>
              </a:ext>
            </a:extLst>
          </p:cNvPr>
          <p:cNvCxnSpPr/>
          <p:nvPr/>
        </p:nvCxnSpPr>
        <p:spPr>
          <a:xfrm>
            <a:off x="4468268" y="2033333"/>
            <a:ext cx="12218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D2FA7BCF-B8CE-4EFF-B485-98F12D388706}"/>
              </a:ext>
            </a:extLst>
          </p:cNvPr>
          <p:cNvSpPr txBox="1"/>
          <p:nvPr/>
        </p:nvSpPr>
        <p:spPr>
          <a:xfrm>
            <a:off x="3032564" y="3037042"/>
            <a:ext cx="13869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1         0.88      1.01     0.17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BC4ADD4-57B7-4C19-ABFA-F311C43AAF3A}"/>
              </a:ext>
            </a:extLst>
          </p:cNvPr>
          <p:cNvSpPr txBox="1"/>
          <p:nvPr/>
        </p:nvSpPr>
        <p:spPr>
          <a:xfrm>
            <a:off x="3037568" y="2622454"/>
            <a:ext cx="13869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1        0.78      0.78      0.47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35D770D-5A9B-4276-8796-EE856C6EB105}"/>
              </a:ext>
            </a:extLst>
          </p:cNvPr>
          <p:cNvSpPr txBox="1"/>
          <p:nvPr/>
        </p:nvSpPr>
        <p:spPr>
          <a:xfrm>
            <a:off x="809072" y="1623475"/>
            <a:ext cx="274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8E4184F6-565C-45B2-BB49-3BF98F8D2495}"/>
              </a:ext>
            </a:extLst>
          </p:cNvPr>
          <p:cNvSpPr/>
          <p:nvPr/>
        </p:nvSpPr>
        <p:spPr>
          <a:xfrm>
            <a:off x="2171845" y="2600434"/>
            <a:ext cx="87075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3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Fold change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28AF9C38-91F0-4AAF-A590-06074AFADE46}"/>
              </a:ext>
            </a:extLst>
          </p:cNvPr>
          <p:cNvSpPr/>
          <p:nvPr/>
        </p:nvSpPr>
        <p:spPr>
          <a:xfrm>
            <a:off x="2154975" y="3021653"/>
            <a:ext cx="87075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3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Fold change</a:t>
            </a:r>
          </a:p>
        </p:txBody>
      </p:sp>
      <p:sp>
        <p:nvSpPr>
          <p:cNvPr id="2" name="Rectangle 1"/>
          <p:cNvSpPr/>
          <p:nvPr/>
        </p:nvSpPr>
        <p:spPr>
          <a:xfrm>
            <a:off x="809072" y="68310"/>
            <a:ext cx="7716592" cy="15414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6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ffect of combination therapy on interaction of ERα with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egulators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, cell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ycle progression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and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 cycle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teins (C)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F-7 cells were treated with E2 (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8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) in the presence or absence of ERX-11(5 µM), or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lbociclib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100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or ERX-11+palbociclib for 72 h. Total lysates were subjected to immunoprecipitation using control IgG or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R</a:t>
            </a:r>
            <a:r>
              <a:rPr lang="el-GR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tibody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Status of SRC1 and SRC3 association with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R</a:t>
            </a:r>
            <a:r>
              <a:rPr lang="el-GR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analyzed using Western blotting of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precipitates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(B) MCF-7 and MCF-7/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mR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were treated with E2 (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8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) in the presence or absence of ERX-11(1 µM), or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lbociclib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0.25 µM), or ERX-11+palbociclib for 48 h and the status of cell cycle were analyzed by flow cytometry. (C) MCF-7 cells treated with E2 (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8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) in the presence or absence of ERX-11,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lbociclib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ERX-11+palbociclib and the levels of cyclin D1, p21 and pERK1/2 were analyzed by western blotting. 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83423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7" name="Picture 3" descr="Z:\Surya\Surya Project data\CDK inhibitor project\MASS SPEC\pathway analysis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875" y="1243013"/>
            <a:ext cx="6318250" cy="43703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713350" y="316461"/>
            <a:ext cx="7814788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7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e selective pathways uniquely altered by combination therapy are shown in the plot.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teins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hibiting ≥ 1.5-fold change in relative quantity after treatment with the drug combination (ERX-11+palbociclib) compared to vehicle were uploaded into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actome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100" u="sng" dirty="0">
                <a:solidFill>
                  <a:srgbClr val="00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3"/>
              </a:rPr>
              <a:t>https://reactome.org/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for pathway analysis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37611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728221"/>
              </p:ext>
            </p:extLst>
          </p:nvPr>
        </p:nvGraphicFramePr>
        <p:xfrm>
          <a:off x="625405" y="1600205"/>
          <a:ext cx="7893190" cy="4387769"/>
        </p:xfrm>
        <a:graphic>
          <a:graphicData uri="http://schemas.openxmlformats.org/drawingml/2006/table">
            <a:tbl>
              <a:tblPr>
                <a:tableStyleId>{EB9631B5-78F2-41C9-869B-9F39066F8104}</a:tableStyleId>
              </a:tblPr>
              <a:tblGrid>
                <a:gridCol w="36727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504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5048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5048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5048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1426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0419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Treatmen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Rati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2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Prote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Vehi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ERX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alb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ERX-11+Palb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Palbo/Vehi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ERX-11+Palbo/Vehi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uble-strand-break repair protein rad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08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67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14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78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roliferation marker protein Ki-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19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40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60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81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NA replication licensing factor MCM2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16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08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7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12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7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Histone PARylation factor 1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09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18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09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93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NA replication licensing factor MCM6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47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36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64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39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NA damage-binding protein 2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53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38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04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28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NA-splicing endonuclease subunit Sen15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16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85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85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73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biquitin-conjugating enzyme E2 S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84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90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85E+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93E+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hosphatidylinositol 3-kinase regulatory subunit alpha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82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14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46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43E+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.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biquitin-conjugating enzyme E2 C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2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30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5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09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DNA (cytosine-5)-methyltransferase 1</a:t>
                      </a: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28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71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67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94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1038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</a:rPr>
                        <a:t>Arf</a:t>
                      </a:r>
                      <a:r>
                        <a:rPr lang="en-US" sz="900" u="none" strike="noStrike" dirty="0">
                          <a:effectLst/>
                        </a:rPr>
                        <a:t>-GAP with coiled-coil, ANK repeat and PH domain-containing protein 2</a:t>
                      </a: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64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7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8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12E+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.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DH dehydrogenase [ubiquinone] complex I, assembly factor 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64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06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18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50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plicing factor 3B subunit 5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9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22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78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66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robable RNA-binding protein EIF1AD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03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8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99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13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7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uclear transcription factor Y subunit gamm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17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79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95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42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uclear receptor corepressor 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03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73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67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15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9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nscriptional coactivator YAP1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48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00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4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48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9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Histone PARylation factor 1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09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18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09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93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Exosome complex component RRP40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83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36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83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77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3 small nucleolar RNA-associated protein 6 homolog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65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34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50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36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9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nsmembrane and ubiquitin-like domain-containing protein 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02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06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33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59E+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TP-dependent RNA helicase DDX55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92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46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70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50E+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AG family molecular chaperone regulator 5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4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02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1E+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15E+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ctin, cytoplasmic 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56E+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67E+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86E+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54E+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.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9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4627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lyceraldehyde-3-phosphate dehydrogenase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13E+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91E+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06E+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11E+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0.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0.9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604" marR="8604" marT="8604" marB="0" anchor="b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741815" y="417915"/>
            <a:ext cx="769973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8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sults of quantitative data for few selective proteins from DIA analysis are shown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tal spectral counts and total protein fragment intensities normalized across samples in Scaffold Q+S and Scaffold DIA, respectively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28972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17A63EF-70D1-4D7D-9B7F-E7A90EDD20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3094" y="3335082"/>
            <a:ext cx="2025396" cy="2560320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4EE7E9DA-4664-49AF-BACB-7C810D8125B6}"/>
              </a:ext>
            </a:extLst>
          </p:cNvPr>
          <p:cNvGrpSpPr/>
          <p:nvPr/>
        </p:nvGrpSpPr>
        <p:grpSpPr>
          <a:xfrm>
            <a:off x="1276061" y="2229119"/>
            <a:ext cx="4873582" cy="4310361"/>
            <a:chOff x="724565" y="616287"/>
            <a:chExt cx="4549639" cy="4029870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004E5732-ABF3-4851-9EDF-D29ECB7E17DE}"/>
                </a:ext>
              </a:extLst>
            </p:cNvPr>
            <p:cNvSpPr/>
            <p:nvPr/>
          </p:nvSpPr>
          <p:spPr>
            <a:xfrm>
              <a:off x="1639684" y="616287"/>
              <a:ext cx="632880" cy="25897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FE53382C-8075-44F6-A756-E4706ECE56C3}"/>
                </a:ext>
              </a:extLst>
            </p:cNvPr>
            <p:cNvSpPr/>
            <p:nvPr/>
          </p:nvSpPr>
          <p:spPr>
            <a:xfrm>
              <a:off x="1606762" y="4356013"/>
              <a:ext cx="665802" cy="25897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RX-11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27F270C-00F8-4D08-BDFA-FF17E9E86ACB}"/>
                </a:ext>
              </a:extLst>
            </p:cNvPr>
            <p:cNvSpPr/>
            <p:nvPr/>
          </p:nvSpPr>
          <p:spPr>
            <a:xfrm>
              <a:off x="3890738" y="625594"/>
              <a:ext cx="632880" cy="2589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lbo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EDB005F1-5E4E-4BDE-A90B-5A08B7D66EFC}"/>
                </a:ext>
              </a:extLst>
            </p:cNvPr>
            <p:cNvSpPr/>
            <p:nvPr/>
          </p:nvSpPr>
          <p:spPr>
            <a:xfrm>
              <a:off x="3595937" y="4387183"/>
              <a:ext cx="1222482" cy="25897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RX-11 +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lbo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50E2E27-BAF6-4903-96B2-6041BFB8085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3882" y="884568"/>
              <a:ext cx="2134051" cy="17097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338DB08-D3B7-4E96-BC8B-2004B56E590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0153" y="884568"/>
              <a:ext cx="2134051" cy="170979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3EDB4258-F445-4260-B68B-7F93FBAC9F6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0153" y="2633884"/>
              <a:ext cx="2134051" cy="170979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0C46C18-A90F-4AF9-8261-877AEA6295D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3882" y="2633884"/>
              <a:ext cx="2134051" cy="170979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12" name="Subtitle 2">
              <a:extLst>
                <a:ext uri="{FF2B5EF4-FFF2-40B4-BE49-F238E27FC236}">
                  <a16:creationId xmlns:a16="http://schemas.microsoft.com/office/drawing/2014/main" id="{B20DCED8-35D1-4A36-839D-13DE5EF9CE35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315315" y="1630916"/>
              <a:ext cx="1035596" cy="217095"/>
            </a:xfrm>
            <a:prstGeom prst="rect">
              <a:avLst/>
            </a:prstGeom>
          </p:spPr>
          <p:txBody>
            <a:bodyPr vert="horz" lIns="68580" tIns="34290" rIns="68580" bIns="34290" rtlCol="0">
              <a:noAutofit/>
            </a:bodyPr>
            <a:lstStyle>
              <a:lvl1pPr marL="0" indent="0" algn="ctr" defTabSz="914400" rtl="0" eaLnBrk="1" latinLnBrk="0" hangingPunct="1">
                <a:spcBef>
                  <a:spcPct val="20000"/>
                </a:spcBef>
                <a:buFont typeface="Arial" pitchFamily="34" charset="0"/>
                <a:buNone/>
                <a:defRPr sz="3200" kern="1200">
                  <a:solidFill>
                    <a:schemeClr val="tx1">
                      <a:tint val="75000"/>
                    </a:schemeClr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spcBef>
                  <a:spcPct val="20000"/>
                </a:spcBef>
                <a:buFont typeface="Arial" pitchFamily="34" charset="0"/>
                <a:buNone/>
                <a:defRPr sz="2800" kern="1200">
                  <a:solidFill>
                    <a:schemeClr val="tx1">
                      <a:tint val="75000"/>
                    </a:schemeClr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spcBef>
                  <a:spcPct val="20000"/>
                </a:spcBef>
                <a:buFont typeface="Arial" pitchFamily="34" charset="0"/>
                <a:buNone/>
                <a:defRPr sz="2400" kern="1200">
                  <a:solidFill>
                    <a:schemeClr val="tx1">
                      <a:tint val="75000"/>
                    </a:schemeClr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spcBef>
                  <a:spcPct val="20000"/>
                </a:spcBef>
                <a:buFont typeface="Arial" pitchFamily="34" charset="0"/>
                <a:buNone/>
                <a:defRPr sz="2000" kern="1200">
                  <a:solidFill>
                    <a:schemeClr val="tx1">
                      <a:tint val="75000"/>
                    </a:schemeClr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spcBef>
                  <a:spcPct val="20000"/>
                </a:spcBef>
                <a:buFont typeface="Arial" pitchFamily="34" charset="0"/>
                <a:buNone/>
                <a:defRPr sz="2000" kern="1200">
                  <a:solidFill>
                    <a:schemeClr val="tx1">
                      <a:tint val="75000"/>
                    </a:schemeClr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spcBef>
                  <a:spcPct val="20000"/>
                </a:spcBef>
                <a:buFont typeface="Arial" pitchFamily="34" charset="0"/>
                <a:buNone/>
                <a:defRPr sz="2000" kern="1200">
                  <a:solidFill>
                    <a:schemeClr val="tx1">
                      <a:tint val="75000"/>
                    </a:schemeClr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spcBef>
                  <a:spcPct val="20000"/>
                </a:spcBef>
                <a:buFont typeface="Arial" pitchFamily="34" charset="0"/>
                <a:buNone/>
                <a:defRPr sz="2000" kern="1200">
                  <a:solidFill>
                    <a:schemeClr val="tx1">
                      <a:tint val="75000"/>
                    </a:schemeClr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spcBef>
                  <a:spcPct val="20000"/>
                </a:spcBef>
                <a:buFont typeface="Arial" pitchFamily="34" charset="0"/>
                <a:buNone/>
                <a:defRPr sz="2000" kern="1200">
                  <a:solidFill>
                    <a:schemeClr val="tx1">
                      <a:tint val="75000"/>
                    </a:schemeClr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spcBef>
                  <a:spcPct val="20000"/>
                </a:spcBef>
                <a:buFont typeface="Arial" pitchFamily="34" charset="0"/>
                <a:buNone/>
                <a:defRPr sz="2000" kern="1200">
                  <a:solidFill>
                    <a:schemeClr val="tx1">
                      <a:tint val="75000"/>
                    </a:schemeClr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US" sz="1200" dirty="0">
                  <a:solidFill>
                    <a:schemeClr val="tx1"/>
                  </a:solidFill>
                </a:rPr>
                <a:t>DAPI+ </a:t>
              </a:r>
              <a:r>
                <a:rPr lang="el-GR" sz="1200" dirty="0">
                  <a:solidFill>
                    <a:schemeClr val="tx1"/>
                  </a:solidFill>
                </a:rPr>
                <a:t>γ</a:t>
              </a:r>
              <a:r>
                <a:rPr lang="en-US" sz="1200" dirty="0">
                  <a:solidFill>
                    <a:schemeClr val="tx1"/>
                  </a:solidFill>
                </a:rPr>
                <a:t>-H2AX</a:t>
              </a:r>
            </a:p>
          </p:txBody>
        </p:sp>
      </p:grpSp>
      <p:sp>
        <p:nvSpPr>
          <p:cNvPr id="13" name="Subtitle 2">
            <a:extLst>
              <a:ext uri="{FF2B5EF4-FFF2-40B4-BE49-F238E27FC236}">
                <a16:creationId xmlns:a16="http://schemas.microsoft.com/office/drawing/2014/main" id="{674C4DDB-7B9E-4169-A7C7-C3E4E5394FE9}"/>
              </a:ext>
            </a:extLst>
          </p:cNvPr>
          <p:cNvSpPr txBox="1">
            <a:spLocks/>
          </p:cNvSpPr>
          <p:nvPr/>
        </p:nvSpPr>
        <p:spPr>
          <a:xfrm rot="16200000">
            <a:off x="853052" y="5055511"/>
            <a:ext cx="1113090" cy="232553"/>
          </a:xfrm>
          <a:prstGeom prst="rect">
            <a:avLst/>
          </a:prstGeom>
        </p:spPr>
        <p:txBody>
          <a:bodyPr vert="horz" lIns="68580" tIns="34290" rIns="68580" bIns="34290" rtlCol="0">
            <a:no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200" dirty="0">
                <a:solidFill>
                  <a:schemeClr val="tx1"/>
                </a:solidFill>
              </a:rPr>
              <a:t>DAPI+ </a:t>
            </a:r>
            <a:r>
              <a:rPr lang="el-GR" sz="1200" dirty="0">
                <a:solidFill>
                  <a:schemeClr val="tx1"/>
                </a:solidFill>
              </a:rPr>
              <a:t>γ</a:t>
            </a:r>
            <a:r>
              <a:rPr lang="en-US" sz="1200" dirty="0">
                <a:solidFill>
                  <a:schemeClr val="tx1"/>
                </a:solidFill>
              </a:rPr>
              <a:t>-H2AX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56401A7-D74A-4DA0-8419-CB58D06277D1}"/>
              </a:ext>
            </a:extLst>
          </p:cNvPr>
          <p:cNvSpPr txBox="1"/>
          <p:nvPr/>
        </p:nvSpPr>
        <p:spPr>
          <a:xfrm>
            <a:off x="7716020" y="70020"/>
            <a:ext cx="7970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046569" y="577080"/>
            <a:ext cx="759678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just"/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9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ffect of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X-11+palbociclib 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mbination </a:t>
            </a:r>
            <a:r>
              <a:rPr lang="en-US" sz="120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rapy on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γH2AX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ci. MCF-7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 were treated with E2 (10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8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) in the presence or absence of ERX-11 (5 µM), or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lbocicli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250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or ERX-11+palbociclib for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 h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the γH2AX foci was captured using fluorescent microscope and the number of foci was calculated and plotted as histogram. Data are represented as mean ± SE. *p &lt; 0.05; **p &lt; 0.01; ****p &lt; 0.001.</a:t>
            </a:r>
          </a:p>
        </p:txBody>
      </p:sp>
    </p:spTree>
    <p:extLst>
      <p:ext uri="{BB962C8B-B14F-4D97-AF65-F5344CB8AC3E}">
        <p14:creationId xmlns:p14="http://schemas.microsoft.com/office/powerpoint/2010/main" val="1337958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65</TotalTime>
  <Words>917</Words>
  <Application>Microsoft Office PowerPoint</Application>
  <PresentationFormat>On-screen Show (4:3)</PresentationFormat>
  <Paragraphs>325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T Southwester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nesh Raj</dc:creator>
  <cp:lastModifiedBy>Vadlamudi, Ratna</cp:lastModifiedBy>
  <cp:revision>267</cp:revision>
  <cp:lastPrinted>2019-12-17T00:51:36Z</cp:lastPrinted>
  <dcterms:created xsi:type="dcterms:W3CDTF">2018-12-07T21:12:30Z</dcterms:created>
  <dcterms:modified xsi:type="dcterms:W3CDTF">2019-12-18T00:09:19Z</dcterms:modified>
</cp:coreProperties>
</file>